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sldIdLst>
    <p:sldId id="270" r:id="rId2"/>
    <p:sldId id="262" r:id="rId3"/>
    <p:sldId id="263" r:id="rId4"/>
    <p:sldId id="272" r:id="rId5"/>
    <p:sldId id="273" r:id="rId6"/>
    <p:sldId id="274" r:id="rId7"/>
    <p:sldId id="275" r:id="rId8"/>
    <p:sldId id="276" r:id="rId9"/>
    <p:sldId id="277" r:id="rId10"/>
    <p:sldId id="256" r:id="rId11"/>
    <p:sldId id="257" r:id="rId12"/>
    <p:sldId id="258" r:id="rId13"/>
    <p:sldId id="259" r:id="rId14"/>
    <p:sldId id="264" r:id="rId15"/>
    <p:sldId id="265" r:id="rId16"/>
    <p:sldId id="266" r:id="rId17"/>
    <p:sldId id="267" r:id="rId18"/>
    <p:sldId id="268" r:id="rId19"/>
    <p:sldId id="269" r:id="rId2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45" autoAdjust="0"/>
    <p:restoredTop sz="94660"/>
  </p:normalViewPr>
  <p:slideViewPr>
    <p:cSldViewPr snapToGrid="0">
      <p:cViewPr>
        <p:scale>
          <a:sx n="90" d="100"/>
          <a:sy n="90" d="100"/>
        </p:scale>
        <p:origin x="1962" y="-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330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312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816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1132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45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560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01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2081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919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2826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179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D740D-F725-4E4B-8527-899E1F7B6C27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1D54D-4D15-4690-ABA8-677BE8FBB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7769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jpe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cid:image002.png@01D53D4E.5F0BF420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4AAAEEE-D3CF-5975-3C3E-9E7302E0E42B}"/>
              </a:ext>
            </a:extLst>
          </p:cNvPr>
          <p:cNvSpPr txBox="1"/>
          <p:nvPr/>
        </p:nvSpPr>
        <p:spPr>
          <a:xfrm>
            <a:off x="342900" y="1428729"/>
            <a:ext cx="6172200" cy="59730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of the Arabidopsis redox-related LEA protein, </a:t>
            </a:r>
            <a:r>
              <a:rPr lang="en-GB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2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regulated by ERF, NAC and WRKY transcription factors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elly V. Evans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lspeth Ransom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wapna Nayakoti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Ben Wilding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aezah Mohd Salleh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rena </a:t>
            </a:r>
            <a:r>
              <a:rPr lang="en-GB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žina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eselotte Erber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armen Tse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laire Hill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rzysztof Polanski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istair Holland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herien Bukhat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obert J. Herbert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Barend H. J. de Graaf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atherine Denby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icky Buchanan-Wollaston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ilary J Rogers</a:t>
            </a:r>
            <a:r>
              <a:rPr lang="en-GB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 of Biosciences, Cardiff University Sir Martin Evans Building, Museum Avenue, Cardiff CF10 3AT, UK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sciences, Faculty of Science,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knolog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laysia, 81310, Johor Bahru, Johor, Malaysia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 of Life Sciences, University of Warwick, Coventry CV4 7AL, UK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 of Science and the Environment, University of Worcester, Henwick Grove, Worcester, WR2 6AJ, UK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ntre for Novel Agricultural Products (CNAP), Department of Biology, University of York, Heslington, York, YO10 5DD</a:t>
            </a:r>
            <a:r>
              <a:rPr lang="en-GB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lary J Rogers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s and Tables</a:t>
            </a:r>
            <a:endParaRPr lang="en-GB" sz="14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00167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7584F05-0FD1-7CFE-04B7-88F60224DE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9585" y="773917"/>
            <a:ext cx="5015230" cy="1913255"/>
          </a:xfrm>
          <a:prstGeom prst="rect">
            <a:avLst/>
          </a:prstGeom>
          <a:noFill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B5C648-521D-6EA0-3C92-81625FC94EF2}"/>
              </a:ext>
            </a:extLst>
          </p:cNvPr>
          <p:cNvSpPr txBox="1"/>
          <p:nvPr/>
        </p:nvSpPr>
        <p:spPr>
          <a:xfrm>
            <a:off x="921385" y="858221"/>
            <a:ext cx="3797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rky63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1g66600; SALK_068280C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EB87592-4CA4-B0E3-1582-56433BD30D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8294" t="1" r="-1" b="-6321"/>
          <a:stretch/>
        </p:blipFill>
        <p:spPr>
          <a:xfrm>
            <a:off x="497842" y="3247741"/>
            <a:ext cx="2527182" cy="1483283"/>
          </a:xfrm>
          <a:prstGeom prst="rect">
            <a:avLst/>
          </a:prstGeom>
        </p:spPr>
      </p:pic>
      <p:sp>
        <p:nvSpPr>
          <p:cNvPr id="13" name="Text Box 2">
            <a:extLst>
              <a:ext uri="{FF2B5EF4-FFF2-40B4-BE49-F238E27FC236}">
                <a16:creationId xmlns:a16="http://schemas.microsoft.com/office/drawing/2014/main" id="{69F9CD46-A618-ED03-C2EC-74F0356561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808" y="3740795"/>
            <a:ext cx="4762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0.5kb</a:t>
            </a:r>
            <a:endParaRPr lang="en-GB" sz="110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4" name="Text Box 2">
            <a:extLst>
              <a:ext uri="{FF2B5EF4-FFF2-40B4-BE49-F238E27FC236}">
                <a16:creationId xmlns:a16="http://schemas.microsoft.com/office/drawing/2014/main" id="{C3DB9DC2-9988-9E6E-4ACF-84983B2D56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9893" y="6329880"/>
            <a:ext cx="4762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 dirty="0"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0.3kb </a:t>
            </a:r>
            <a:endParaRPr lang="en-GB" sz="1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4BEA083-66F2-E25B-3A4D-B6954C7DFC94}"/>
              </a:ext>
            </a:extLst>
          </p:cNvPr>
          <p:cNvCxnSpPr/>
          <p:nvPr/>
        </p:nvCxnSpPr>
        <p:spPr>
          <a:xfrm>
            <a:off x="332048" y="3919230"/>
            <a:ext cx="2952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0744157-4137-7DE4-2E7D-0C3D483E56C6}"/>
              </a:ext>
            </a:extLst>
          </p:cNvPr>
          <p:cNvCxnSpPr>
            <a:cxnSpLocks/>
          </p:cNvCxnSpPr>
          <p:nvPr/>
        </p:nvCxnSpPr>
        <p:spPr>
          <a:xfrm flipH="1">
            <a:off x="5154755" y="6424740"/>
            <a:ext cx="2952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 Box 2">
            <a:extLst>
              <a:ext uri="{FF2B5EF4-FFF2-40B4-BE49-F238E27FC236}">
                <a16:creationId xmlns:a16="http://schemas.microsoft.com/office/drawing/2014/main" id="{A7BF0071-20BA-66CB-CEEB-A1EC5999CC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766" y="5033045"/>
            <a:ext cx="3238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8" name="Text Box 2">
            <a:extLst>
              <a:ext uri="{FF2B5EF4-FFF2-40B4-BE49-F238E27FC236}">
                <a16:creationId xmlns:a16="http://schemas.microsoft.com/office/drawing/2014/main" id="{07EE14BA-C05B-C1F9-63A3-03F314B189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841" y="1360805"/>
            <a:ext cx="3238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02845A6-68C5-58C8-7D33-3FC1A96C0852}"/>
              </a:ext>
            </a:extLst>
          </p:cNvPr>
          <p:cNvSpPr txBox="1"/>
          <p:nvPr/>
        </p:nvSpPr>
        <p:spPr>
          <a:xfrm>
            <a:off x="372428" y="7404651"/>
            <a:ext cx="594995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Fig. </a:t>
            </a:r>
            <a:r>
              <a:rPr lang="en-GB" sz="1200" b="1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.  Screening of </a:t>
            </a:r>
            <a:r>
              <a:rPr lang="en-GB" sz="1200" b="1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wrky63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(At1g66600; SALK_068280C) plants for homozygous plants with the T-DNA insertion. Map of </a:t>
            </a:r>
            <a:r>
              <a:rPr lang="en-GB" sz="1200" b="1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WRKY63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showing T-DNA insertion site (A) 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FP= Forward primer, RP = Reverse primer.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Gels: (B) Lb1a and forward primers, (C) WRKY63 forward and reverse primers. 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Lanes 1 – 6: DNA samples extracted from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wrky63 Arabidopsis. 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Wild type genomic DNA (G) was used as a second negative control for (B) and used as a positive control for (C). The negative (-) control was water. The ladder (L) was the 1kb plus DNA ladder (Invitrogen).  Lines 2 and 5 are heterozygous as a product of the correct size is obtained from  internal gene primers Seeds from plants  1,3,4, and 6 were used for further work.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E15642E-7A70-660C-CCC5-0AF2917658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1" t="61128" b="225"/>
          <a:stretch/>
        </p:blipFill>
        <p:spPr>
          <a:xfrm>
            <a:off x="659766" y="5354670"/>
            <a:ext cx="4494990" cy="169027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E70E67F-6927-D363-37E3-6A3FA87D905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1" t="-3215" b="225"/>
          <a:stretch/>
        </p:blipFill>
        <p:spPr>
          <a:xfrm>
            <a:off x="659765" y="2593046"/>
            <a:ext cx="4494990" cy="4504408"/>
          </a:xfrm>
          <a:prstGeom prst="rect">
            <a:avLst/>
          </a:prstGeom>
        </p:spPr>
      </p:pic>
      <p:sp>
        <p:nvSpPr>
          <p:cNvPr id="10" name="Text Box 2">
            <a:extLst>
              <a:ext uri="{FF2B5EF4-FFF2-40B4-BE49-F238E27FC236}">
                <a16:creationId xmlns:a16="http://schemas.microsoft.com/office/drawing/2014/main" id="{472B6384-E8EC-5399-DCAD-75F07319D2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7331" y="5684292"/>
            <a:ext cx="2962275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00" dirty="0">
                <a:solidFill>
                  <a:srgbClr val="FFFFFF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1      2     3     4     5      6     G       -</a:t>
            </a:r>
            <a:endParaRPr lang="en-GB" sz="1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1" name="Text Box 2">
            <a:extLst>
              <a:ext uri="{FF2B5EF4-FFF2-40B4-BE49-F238E27FC236}">
                <a16:creationId xmlns:a16="http://schemas.microsoft.com/office/drawing/2014/main" id="{B17C766D-CB7C-BC88-6212-DF9511EA6E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247" y="3221076"/>
            <a:ext cx="2447925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00" dirty="0">
                <a:solidFill>
                  <a:srgbClr val="FFFFFF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 1      2       3     4     5    6       G     -</a:t>
            </a:r>
            <a:endParaRPr lang="en-GB" sz="1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2" name="Text Box 2">
            <a:extLst>
              <a:ext uri="{FF2B5EF4-FFF2-40B4-BE49-F238E27FC236}">
                <a16:creationId xmlns:a16="http://schemas.microsoft.com/office/drawing/2014/main" id="{8008D08F-C316-3B60-BC55-E11E4E640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9508" y="2750854"/>
            <a:ext cx="3238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 Box 2">
            <a:extLst>
              <a:ext uri="{FF2B5EF4-FFF2-40B4-BE49-F238E27FC236}">
                <a16:creationId xmlns:a16="http://schemas.microsoft.com/office/drawing/2014/main" id="{63872ED3-8679-93C2-0B4C-3661B8EDFD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4663" y="5318795"/>
            <a:ext cx="3238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2459050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98B1D15-2222-E727-D15C-E31922D5CAFB}"/>
              </a:ext>
            </a:extLst>
          </p:cNvPr>
          <p:cNvSpPr txBox="1"/>
          <p:nvPr/>
        </p:nvSpPr>
        <p:spPr>
          <a:xfrm>
            <a:off x="921385" y="1317356"/>
            <a:ext cx="3797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c042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2G43000; SALK_03647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71C91AD-8B5D-36AC-28B0-7B38322FFEA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86" t="-10965" r="-2962" b="-11273"/>
          <a:stretch/>
        </p:blipFill>
        <p:spPr bwMode="auto">
          <a:xfrm>
            <a:off x="1484027" y="3521432"/>
            <a:ext cx="3953076" cy="222151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 Box 2">
            <a:extLst>
              <a:ext uri="{FF2B5EF4-FFF2-40B4-BE49-F238E27FC236}">
                <a16:creationId xmlns:a16="http://schemas.microsoft.com/office/drawing/2014/main" id="{33D8F36B-3C58-DDB5-CE5B-B31E8796E6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8895" y="3720709"/>
            <a:ext cx="3238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>
                <a:solidFill>
                  <a:srgbClr val="FFFFFF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L</a:t>
            </a:r>
            <a:endParaRPr lang="en-GB" sz="110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550F5F57-2307-BA85-EE8A-D93643CFF4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16040" y="3720709"/>
            <a:ext cx="2962275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00">
                <a:solidFill>
                  <a:srgbClr val="FFFFFF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1        2         3      4      5      6     7       8      G        -</a:t>
            </a:r>
            <a:endParaRPr lang="en-GB" sz="110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6" name="Text Box 2">
            <a:extLst>
              <a:ext uri="{FF2B5EF4-FFF2-40B4-BE49-F238E27FC236}">
                <a16:creationId xmlns:a16="http://schemas.microsoft.com/office/drawing/2014/main" id="{6CC82D1E-BF9D-7EC3-178C-D5127608C0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0583" y="4555345"/>
            <a:ext cx="476250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 dirty="0"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1.1kb</a:t>
            </a:r>
            <a:endParaRPr lang="en-GB" sz="1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EC72BDE-B4A3-063B-2839-994DF0D2E444}"/>
              </a:ext>
            </a:extLst>
          </p:cNvPr>
          <p:cNvCxnSpPr/>
          <p:nvPr/>
        </p:nvCxnSpPr>
        <p:spPr>
          <a:xfrm flipH="1">
            <a:off x="5403135" y="4760212"/>
            <a:ext cx="26733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881510A6-7BAB-DD9C-34E7-580C15FE4EEA}"/>
              </a:ext>
            </a:extLst>
          </p:cNvPr>
          <p:cNvSpPr txBox="1"/>
          <p:nvPr/>
        </p:nvSpPr>
        <p:spPr>
          <a:xfrm>
            <a:off x="1306295" y="5742946"/>
            <a:ext cx="424540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Fig. 4. Checking </a:t>
            </a:r>
            <a:r>
              <a:rPr lang="en-GB" sz="1200" b="1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anac042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plants for  homozygosity s using the ANAC042 forward and reverse primers. (A) 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map of T-DNA insertion site (B) Lanes 1 – 8: DNA extracted from a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nac042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plants. WT genomic DNA (G) was used as a positive control. The negative (-) control was water. The ladder (L) was the 1kb plus DNA ladder (Invitrogen). The lack of product of the correct size in the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anac042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plants but presence in the WT DNA indicates that the anaco42 plants are homozygous for the insertion.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63373C4-7ACC-DCC6-4032-307ADF8A3A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61" t="35682" r="72591" b="43926"/>
          <a:stretch/>
        </p:blipFill>
        <p:spPr>
          <a:xfrm>
            <a:off x="1306295" y="1892500"/>
            <a:ext cx="4130808" cy="134506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48D1F33-D027-19DF-FCD0-C4CD6EAD420E}"/>
              </a:ext>
            </a:extLst>
          </p:cNvPr>
          <p:cNvSpPr txBox="1"/>
          <p:nvPr/>
        </p:nvSpPr>
        <p:spPr>
          <a:xfrm>
            <a:off x="1599465" y="2176372"/>
            <a:ext cx="81915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i="1" dirty="0"/>
              <a:t>anac04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E5A7B2D-499E-4A34-DFE3-CF80EC9C1DF3}"/>
              </a:ext>
            </a:extLst>
          </p:cNvPr>
          <p:cNvSpPr txBox="1"/>
          <p:nvPr/>
        </p:nvSpPr>
        <p:spPr>
          <a:xfrm>
            <a:off x="921385" y="2077503"/>
            <a:ext cx="3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F886C7-4FD1-0B6B-C803-89EE1DAA0B21}"/>
              </a:ext>
            </a:extLst>
          </p:cNvPr>
          <p:cNvSpPr txBox="1"/>
          <p:nvPr/>
        </p:nvSpPr>
        <p:spPr>
          <a:xfrm>
            <a:off x="933125" y="3569911"/>
            <a:ext cx="3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026208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8AAFA0A-DD18-DA36-DE03-6B6C93C61890}"/>
              </a:ext>
            </a:extLst>
          </p:cNvPr>
          <p:cNvSpPr txBox="1"/>
          <p:nvPr/>
        </p:nvSpPr>
        <p:spPr>
          <a:xfrm>
            <a:off x="921385" y="1317356"/>
            <a:ext cx="3797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c07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4G17980; SALK_012841C</a:t>
            </a:r>
          </a:p>
        </p:txBody>
      </p:sp>
      <p:pic>
        <p:nvPicPr>
          <p:cNvPr id="3" name="Picture 2" descr="A screen shot of a computer&#10;&#10;Description automatically generated with low confidence">
            <a:extLst>
              <a:ext uri="{FF2B5EF4-FFF2-40B4-BE49-F238E27FC236}">
                <a16:creationId xmlns:a16="http://schemas.microsoft.com/office/drawing/2014/main" id="{CDB44F49-D95C-DCD2-88AE-536048D9E4A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3669"/>
          <a:stretch/>
        </p:blipFill>
        <p:spPr bwMode="auto">
          <a:xfrm>
            <a:off x="921385" y="1594355"/>
            <a:ext cx="4658355" cy="1498633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D2642B0-F8BA-6CFD-2FC3-A8E159C575E8}"/>
              </a:ext>
            </a:extLst>
          </p:cNvPr>
          <p:cNvSpPr txBox="1"/>
          <p:nvPr/>
        </p:nvSpPr>
        <p:spPr>
          <a:xfrm>
            <a:off x="597424" y="8082649"/>
            <a:ext cx="579636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GB" sz="12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5. (A)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p of the 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C071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-DNA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ion site. LP and RP primers, blue arrows. BP primer,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nge arrow. </a:t>
            </a:r>
            <a:r>
              <a:rPr lang="en-GB" sz="12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rect size products in WT and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c071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A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M) and no band in the negative controls (-</a:t>
            </a:r>
            <a:r>
              <a:rPr lang="en-GB" sz="1200" i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</a:t>
            </a:r>
            <a:r>
              <a:rPr lang="en-GB" sz="12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indicate that the line is homozygous. L = 1kb+ DNA ladder.</a:t>
            </a:r>
            <a:endParaRPr lang="en-GB" sz="1200" i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7669AA8B-89B1-AAF7-6553-A148C13F94AB}"/>
              </a:ext>
            </a:extLst>
          </p:cNvPr>
          <p:cNvGrpSpPr/>
          <p:nvPr/>
        </p:nvGrpSpPr>
        <p:grpSpPr>
          <a:xfrm>
            <a:off x="166998" y="3092988"/>
            <a:ext cx="2678253" cy="4642167"/>
            <a:chOff x="1245887" y="5082545"/>
            <a:chExt cx="2678253" cy="4642167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238E40FA-0A80-25FF-CD81-6FB073218305}"/>
                </a:ext>
              </a:extLst>
            </p:cNvPr>
            <p:cNvGrpSpPr/>
            <p:nvPr/>
          </p:nvGrpSpPr>
          <p:grpSpPr>
            <a:xfrm>
              <a:off x="1245887" y="5082545"/>
              <a:ext cx="2663050" cy="4642167"/>
              <a:chOff x="1811371" y="3819229"/>
              <a:chExt cx="2663050" cy="4642167"/>
            </a:xfrm>
          </p:grpSpPr>
          <p:pic>
            <p:nvPicPr>
              <p:cNvPr id="6" name="Picture 5" descr="A rectangular object with lines on it&#10;&#10;Description automatically generated">
                <a:extLst>
                  <a:ext uri="{FF2B5EF4-FFF2-40B4-BE49-F238E27FC236}">
                    <a16:creationId xmlns:a16="http://schemas.microsoft.com/office/drawing/2014/main" id="{1E3ECD50-3261-93B6-6D3D-D474772F33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334" t="15640" r="43242" b="13301"/>
              <a:stretch/>
            </p:blipFill>
            <p:spPr>
              <a:xfrm>
                <a:off x="2561400" y="3819229"/>
                <a:ext cx="1913021" cy="4642167"/>
              </a:xfrm>
              <a:prstGeom prst="rect">
                <a:avLst/>
              </a:prstGeom>
            </p:spPr>
          </p:pic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AD25706A-A181-0AD4-2DF4-B3E48DE66BE5}"/>
                  </a:ext>
                </a:extLst>
              </p:cNvPr>
              <p:cNvCxnSpPr/>
              <p:nvPr/>
            </p:nvCxnSpPr>
            <p:spPr>
              <a:xfrm>
                <a:off x="2352785" y="6448927"/>
                <a:ext cx="467142" cy="0"/>
              </a:xfrm>
              <a:prstGeom prst="straightConnector1">
                <a:avLst/>
              </a:prstGeom>
              <a:ln>
                <a:solidFill>
                  <a:srgbClr val="FFFF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AED19212-0B21-4F14-B362-4745E17DD290}"/>
                  </a:ext>
                </a:extLst>
              </p:cNvPr>
              <p:cNvCxnSpPr/>
              <p:nvPr/>
            </p:nvCxnSpPr>
            <p:spPr>
              <a:xfrm>
                <a:off x="2352785" y="6749716"/>
                <a:ext cx="467142" cy="0"/>
              </a:xfrm>
              <a:prstGeom prst="straightConnector1">
                <a:avLst/>
              </a:prstGeom>
              <a:ln>
                <a:solidFill>
                  <a:srgbClr val="FFFF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3214F48-900D-A7FF-CCB5-12B1F480AAB9}"/>
                  </a:ext>
                </a:extLst>
              </p:cNvPr>
              <p:cNvSpPr txBox="1"/>
              <p:nvPr/>
            </p:nvSpPr>
            <p:spPr>
              <a:xfrm>
                <a:off x="1811371" y="6285549"/>
                <a:ext cx="73392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200" dirty="0"/>
                  <a:t>1000 bp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4EBEFE1-5E1F-F794-1EE1-8E8918F06793}"/>
                  </a:ext>
                </a:extLst>
              </p:cNvPr>
              <p:cNvSpPr txBox="1"/>
              <p:nvPr/>
            </p:nvSpPr>
            <p:spPr>
              <a:xfrm>
                <a:off x="1811371" y="6611216"/>
                <a:ext cx="70475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200" dirty="0"/>
                  <a:t>500 bp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C05285B-164A-1378-3690-AD2336BC2460}"/>
                </a:ext>
              </a:extLst>
            </p:cNvPr>
            <p:cNvSpPr txBox="1"/>
            <p:nvPr/>
          </p:nvSpPr>
          <p:spPr>
            <a:xfrm>
              <a:off x="2585463" y="5702318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LB+RP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4D4C96E-1AAA-32F0-64B7-C8F05980CBB7}"/>
                </a:ext>
              </a:extLst>
            </p:cNvPr>
            <p:cNvSpPr txBox="1"/>
            <p:nvPr/>
          </p:nvSpPr>
          <p:spPr>
            <a:xfrm>
              <a:off x="3190214" y="5702317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LP+RP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351227F-5580-EA8B-9A2B-14F79360A690}"/>
                </a:ext>
              </a:extLst>
            </p:cNvPr>
            <p:cNvSpPr txBox="1"/>
            <p:nvPr/>
          </p:nvSpPr>
          <p:spPr>
            <a:xfrm>
              <a:off x="2585463" y="5993349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WT   M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C4BB194-41F8-05FF-F703-2AF454A6DB24}"/>
                </a:ext>
              </a:extLst>
            </p:cNvPr>
            <p:cNvSpPr txBox="1"/>
            <p:nvPr/>
          </p:nvSpPr>
          <p:spPr>
            <a:xfrm>
              <a:off x="3176855" y="5987711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WT   M</a:t>
              </a:r>
            </a:p>
          </p:txBody>
        </p:sp>
        <p:sp>
          <p:nvSpPr>
            <p:cNvPr id="17" name="Right Brace 16">
              <a:extLst>
                <a:ext uri="{FF2B5EF4-FFF2-40B4-BE49-F238E27FC236}">
                  <a16:creationId xmlns:a16="http://schemas.microsoft.com/office/drawing/2014/main" id="{10D94677-4A17-32E7-8A57-6504FC1C513A}"/>
                </a:ext>
              </a:extLst>
            </p:cNvPr>
            <p:cNvSpPr/>
            <p:nvPr/>
          </p:nvSpPr>
          <p:spPr>
            <a:xfrm rot="16200000" flipV="1">
              <a:off x="2935980" y="5775583"/>
              <a:ext cx="48127" cy="412292"/>
            </a:xfrm>
            <a:prstGeom prst="rightBrac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ight Brace 17">
              <a:extLst>
                <a:ext uri="{FF2B5EF4-FFF2-40B4-BE49-F238E27FC236}">
                  <a16:creationId xmlns:a16="http://schemas.microsoft.com/office/drawing/2014/main" id="{03ECF43A-5AE7-9F2D-8CF7-E4D6BF29972F}"/>
                </a:ext>
              </a:extLst>
            </p:cNvPr>
            <p:cNvSpPr/>
            <p:nvPr/>
          </p:nvSpPr>
          <p:spPr>
            <a:xfrm rot="16200000" flipV="1">
              <a:off x="3525495" y="5773169"/>
              <a:ext cx="48127" cy="412292"/>
            </a:xfrm>
            <a:prstGeom prst="rightBrac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05211DFF-E48D-63A7-7317-F8B00E459D3D}"/>
              </a:ext>
            </a:extLst>
          </p:cNvPr>
          <p:cNvGrpSpPr/>
          <p:nvPr/>
        </p:nvGrpSpPr>
        <p:grpSpPr>
          <a:xfrm>
            <a:off x="3019560" y="3192437"/>
            <a:ext cx="2649708" cy="4542718"/>
            <a:chOff x="5982240" y="3854851"/>
            <a:chExt cx="2649708" cy="4542718"/>
          </a:xfrm>
        </p:grpSpPr>
        <p:pic>
          <p:nvPicPr>
            <p:cNvPr id="21" name="Picture 20" descr="A rectangular object with a black background&#10;&#10;Description automatically generated">
              <a:extLst>
                <a:ext uri="{FF2B5EF4-FFF2-40B4-BE49-F238E27FC236}">
                  <a16:creationId xmlns:a16="http://schemas.microsoft.com/office/drawing/2014/main" id="{F2A13F1F-E90C-9FA6-2D70-6F749C6CAC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1" t="15380" r="43020" b="17029"/>
            <a:stretch/>
          </p:blipFill>
          <p:spPr>
            <a:xfrm>
              <a:off x="6718927" y="3854851"/>
              <a:ext cx="1913021" cy="4542718"/>
            </a:xfrm>
            <a:prstGeom prst="rect">
              <a:avLst/>
            </a:prstGeom>
          </p:spPr>
        </p:pic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92738348-7694-CFE3-F640-F8785353A642}"/>
                </a:ext>
              </a:extLst>
            </p:cNvPr>
            <p:cNvCxnSpPr/>
            <p:nvPr/>
          </p:nvCxnSpPr>
          <p:spPr>
            <a:xfrm>
              <a:off x="6547718" y="5935711"/>
              <a:ext cx="467142" cy="0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B3D7E39C-D5A9-D9E1-D1BF-30A7A97D0BDB}"/>
                </a:ext>
              </a:extLst>
            </p:cNvPr>
            <p:cNvCxnSpPr/>
            <p:nvPr/>
          </p:nvCxnSpPr>
          <p:spPr>
            <a:xfrm>
              <a:off x="6547718" y="6140244"/>
              <a:ext cx="467142" cy="0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FC90AEE-BF34-0127-2BE3-AA1CC7DFB27A}"/>
                </a:ext>
              </a:extLst>
            </p:cNvPr>
            <p:cNvSpPr txBox="1"/>
            <p:nvPr/>
          </p:nvSpPr>
          <p:spPr>
            <a:xfrm>
              <a:off x="5982240" y="5772333"/>
              <a:ext cx="73392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200" dirty="0"/>
                <a:t>1000 bp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FA7987C-E48D-3C9F-0386-DD1750F867EC}"/>
                </a:ext>
              </a:extLst>
            </p:cNvPr>
            <p:cNvSpPr txBox="1"/>
            <p:nvPr/>
          </p:nvSpPr>
          <p:spPr>
            <a:xfrm>
              <a:off x="6011413" y="6001744"/>
              <a:ext cx="70475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200" dirty="0"/>
                <a:t>500 bp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C6FD43C-66D5-054B-E701-47E519B8BF01}"/>
                </a:ext>
              </a:extLst>
            </p:cNvPr>
            <p:cNvSpPr txBox="1"/>
            <p:nvPr/>
          </p:nvSpPr>
          <p:spPr>
            <a:xfrm rot="16200000">
              <a:off x="7158395" y="4447537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LB+RP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A9FB93-EB7D-EA54-83F1-22224291F815}"/>
                </a:ext>
              </a:extLst>
            </p:cNvPr>
            <p:cNvSpPr txBox="1"/>
            <p:nvPr/>
          </p:nvSpPr>
          <p:spPr>
            <a:xfrm rot="16200000">
              <a:off x="7435395" y="4447537"/>
              <a:ext cx="7339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FF00"/>
                  </a:solidFill>
                </a:rPr>
                <a:t>LP+RP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03A94139-8686-9C6D-9384-B68EC6B3324D}"/>
              </a:ext>
            </a:extLst>
          </p:cNvPr>
          <p:cNvSpPr txBox="1"/>
          <p:nvPr/>
        </p:nvSpPr>
        <p:spPr>
          <a:xfrm>
            <a:off x="3928394" y="3332429"/>
            <a:ext cx="733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FFFF00"/>
                </a:solidFill>
              </a:rPr>
              <a:t>-</a:t>
            </a:r>
            <a:r>
              <a:rPr lang="en-GB" sz="1200" dirty="0" err="1">
                <a:solidFill>
                  <a:srgbClr val="FFFF00"/>
                </a:solidFill>
              </a:rPr>
              <a:t>ve</a:t>
            </a:r>
            <a:endParaRPr lang="en-GB" sz="1200" dirty="0">
              <a:solidFill>
                <a:srgbClr val="FFFF00"/>
              </a:solidFill>
            </a:endParaRPr>
          </a:p>
        </p:txBody>
      </p:sp>
      <p:sp>
        <p:nvSpPr>
          <p:cNvPr id="32" name="Right Brace 31">
            <a:extLst>
              <a:ext uri="{FF2B5EF4-FFF2-40B4-BE49-F238E27FC236}">
                <a16:creationId xmlns:a16="http://schemas.microsoft.com/office/drawing/2014/main" id="{DAD71761-AEA8-FDE9-60C9-8C118F9C73C9}"/>
              </a:ext>
            </a:extLst>
          </p:cNvPr>
          <p:cNvSpPr/>
          <p:nvPr/>
        </p:nvSpPr>
        <p:spPr>
          <a:xfrm rot="16200000" flipV="1">
            <a:off x="4271294" y="3451232"/>
            <a:ext cx="48127" cy="412292"/>
          </a:xfrm>
          <a:prstGeom prst="rightBrace">
            <a:avLst/>
          </a:prstGeom>
          <a:ln w="1905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76788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1F6D1402-AA22-9BEF-E032-2BACAED2947B}"/>
              </a:ext>
            </a:extLst>
          </p:cNvPr>
          <p:cNvCxnSpPr>
            <a:cxnSpLocks/>
          </p:cNvCxnSpPr>
          <p:nvPr/>
        </p:nvCxnSpPr>
        <p:spPr>
          <a:xfrm>
            <a:off x="1055672" y="2308116"/>
            <a:ext cx="4430728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B3F967F1-B094-4F0E-0A68-76A8DBF66747}"/>
              </a:ext>
            </a:extLst>
          </p:cNvPr>
          <p:cNvSpPr/>
          <p:nvPr/>
        </p:nvSpPr>
        <p:spPr>
          <a:xfrm rot="10800000">
            <a:off x="2022459" y="1650891"/>
            <a:ext cx="790575" cy="638175"/>
          </a:xfrm>
          <a:prstGeom prst="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D3958A-375B-671B-51B2-708041499979}"/>
              </a:ext>
            </a:extLst>
          </p:cNvPr>
          <p:cNvSpPr txBox="1"/>
          <p:nvPr/>
        </p:nvSpPr>
        <p:spPr>
          <a:xfrm>
            <a:off x="2089133" y="1631842"/>
            <a:ext cx="11001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-DNA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DA9A024-0C84-05EC-8F3E-B4204052BF32}"/>
              </a:ext>
            </a:extLst>
          </p:cNvPr>
          <p:cNvCxnSpPr/>
          <p:nvPr/>
        </p:nvCxnSpPr>
        <p:spPr>
          <a:xfrm>
            <a:off x="1770047" y="2117616"/>
            <a:ext cx="319086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9E66BB35-ABF8-8FF7-D87C-72C1DCFDD33D}"/>
              </a:ext>
            </a:extLst>
          </p:cNvPr>
          <p:cNvCxnSpPr>
            <a:cxnSpLocks/>
          </p:cNvCxnSpPr>
          <p:nvPr/>
        </p:nvCxnSpPr>
        <p:spPr>
          <a:xfrm flipH="1">
            <a:off x="2789223" y="2498616"/>
            <a:ext cx="319086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4572DAF-39F2-EB36-ACA2-65ED19FD6301}"/>
              </a:ext>
            </a:extLst>
          </p:cNvPr>
          <p:cNvSpPr txBox="1"/>
          <p:nvPr/>
        </p:nvSpPr>
        <p:spPr>
          <a:xfrm>
            <a:off x="1758140" y="1874341"/>
            <a:ext cx="523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F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E972B5-1B5F-4684-B599-EAC93C7325C3}"/>
              </a:ext>
            </a:extLst>
          </p:cNvPr>
          <p:cNvSpPr txBox="1"/>
          <p:nvPr/>
        </p:nvSpPr>
        <p:spPr>
          <a:xfrm>
            <a:off x="2789223" y="2498616"/>
            <a:ext cx="523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R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9A2AACDB-A821-2A3E-A112-A371C68A4B03}"/>
              </a:ext>
            </a:extLst>
          </p:cNvPr>
          <p:cNvCxnSpPr/>
          <p:nvPr/>
        </p:nvCxnSpPr>
        <p:spPr>
          <a:xfrm>
            <a:off x="3789347" y="2182893"/>
            <a:ext cx="319086" cy="0"/>
          </a:xfrm>
          <a:prstGeom prst="straightConnector1">
            <a:avLst/>
          </a:prstGeom>
          <a:ln w="28575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2D9958E-1A9A-567B-69B5-D663A73327CC}"/>
              </a:ext>
            </a:extLst>
          </p:cNvPr>
          <p:cNvSpPr txBox="1"/>
          <p:nvPr/>
        </p:nvSpPr>
        <p:spPr>
          <a:xfrm>
            <a:off x="3746483" y="1939618"/>
            <a:ext cx="523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accent1">
                    <a:lumMod val="75000"/>
                  </a:schemeClr>
                </a:solidFill>
              </a:rPr>
              <a:t>CF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6AC1D16-3D1A-0A38-67D2-C2E7C557D604}"/>
              </a:ext>
            </a:extLst>
          </p:cNvPr>
          <p:cNvCxnSpPr>
            <a:cxnSpLocks/>
          </p:cNvCxnSpPr>
          <p:nvPr/>
        </p:nvCxnSpPr>
        <p:spPr>
          <a:xfrm flipH="1">
            <a:off x="4668029" y="2556539"/>
            <a:ext cx="319086" cy="0"/>
          </a:xfrm>
          <a:prstGeom prst="straightConnector1">
            <a:avLst/>
          </a:prstGeom>
          <a:ln w="28575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042F21B-18EC-E151-48D3-9556A6C4ECD4}"/>
              </a:ext>
            </a:extLst>
          </p:cNvPr>
          <p:cNvSpPr txBox="1"/>
          <p:nvPr/>
        </p:nvSpPr>
        <p:spPr>
          <a:xfrm>
            <a:off x="4637072" y="2556539"/>
            <a:ext cx="523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accent1">
                    <a:lumMod val="75000"/>
                  </a:schemeClr>
                </a:solidFill>
              </a:rPr>
              <a:t>CR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F5EEE39-1153-BA66-0D3F-FE13D8F9FFA9}"/>
              </a:ext>
            </a:extLst>
          </p:cNvPr>
          <p:cNvCxnSpPr>
            <a:cxnSpLocks/>
          </p:cNvCxnSpPr>
          <p:nvPr/>
        </p:nvCxnSpPr>
        <p:spPr>
          <a:xfrm flipH="1">
            <a:off x="2022458" y="1559395"/>
            <a:ext cx="319086" cy="0"/>
          </a:xfrm>
          <a:prstGeom prst="straightConnector1">
            <a:avLst/>
          </a:prstGeom>
          <a:ln w="285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DD6DF867-8199-DD0F-4D7E-2157A4C793D5}"/>
              </a:ext>
            </a:extLst>
          </p:cNvPr>
          <p:cNvSpPr txBox="1"/>
          <p:nvPr/>
        </p:nvSpPr>
        <p:spPr>
          <a:xfrm>
            <a:off x="1929590" y="1263345"/>
            <a:ext cx="7381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B050"/>
                </a:solidFill>
              </a:rPr>
              <a:t>GABIKA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C4B735B-477F-6821-39C6-88AB643F73E8}"/>
              </a:ext>
            </a:extLst>
          </p:cNvPr>
          <p:cNvSpPr txBox="1"/>
          <p:nvPr/>
        </p:nvSpPr>
        <p:spPr>
          <a:xfrm>
            <a:off x="1015833" y="6703663"/>
            <a:ext cx="459046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Fig. 6. Selecting </a:t>
            </a:r>
            <a:r>
              <a:rPr lang="en-GB" sz="1200" b="1" i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etr1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homozygous lines from GK-850A03/N481507 and checking over-expressor line (A) 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map of T-DNA insertion site (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) identification of two homozygous lines (34/6.4 and 6.8) based on product of correct size with T-DNA/ gene primer (G + PF) and no product with primers spanning T-DNA insertion site PF+PR (288 bp)  using plant gDNA (W=water). Two heterozygous lines (33/5.2 and 5.4) yield 288 bp band – shown for comparison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(C)</a:t>
            </a:r>
            <a:r>
              <a:rPr lang="en-GB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 Checking over-expressor line using primers in 35S promoter (35S PROK2) and primer CR: correct sized product confirms that transgene is present using plant gDNA 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Picture 27" descr="Text, calendar&#10;&#10;Description automatically generated">
            <a:extLst>
              <a:ext uri="{FF2B5EF4-FFF2-40B4-BE49-F238E27FC236}">
                <a16:creationId xmlns:a16="http://schemas.microsoft.com/office/drawing/2014/main" id="{514D0B02-67E7-055A-3BD3-9121ECEE45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79" t="28094" r="20107" b="20050"/>
          <a:stretch/>
        </p:blipFill>
        <p:spPr>
          <a:xfrm>
            <a:off x="4690372" y="4779352"/>
            <a:ext cx="1066320" cy="1541933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521C913C-2010-B342-864B-517BB58C444E}"/>
              </a:ext>
            </a:extLst>
          </p:cNvPr>
          <p:cNvSpPr txBox="1"/>
          <p:nvPr/>
        </p:nvSpPr>
        <p:spPr>
          <a:xfrm>
            <a:off x="647497" y="1496199"/>
            <a:ext cx="384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A</a:t>
            </a:r>
          </a:p>
        </p:txBody>
      </p:sp>
      <p:pic>
        <p:nvPicPr>
          <p:cNvPr id="19" name="Picture 18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CAC68D4F-32E0-B1A9-E06B-A12F9ED6BE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8" t="19923" r="6721" b="36687"/>
          <a:stretch/>
        </p:blipFill>
        <p:spPr>
          <a:xfrm>
            <a:off x="951073" y="4950093"/>
            <a:ext cx="2503511" cy="169006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D1B4490-3530-BE58-AB90-09082501666A}"/>
              </a:ext>
            </a:extLst>
          </p:cNvPr>
          <p:cNvSpPr txBox="1"/>
          <p:nvPr/>
        </p:nvSpPr>
        <p:spPr>
          <a:xfrm>
            <a:off x="1197268" y="5226203"/>
            <a:ext cx="21350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rabicPlain" startAt="34"/>
            </a:pPr>
            <a:r>
              <a:rPr lang="en-GB" sz="1000" dirty="0"/>
              <a:t>  34    W               34      34     W</a:t>
            </a:r>
          </a:p>
          <a:p>
            <a:r>
              <a:rPr lang="en-GB" sz="1000" dirty="0"/>
              <a:t>6.4    6.8                      6.4     6.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F4AD507-33FB-FE21-FFEA-647CC521C61E}"/>
              </a:ext>
            </a:extLst>
          </p:cNvPr>
          <p:cNvSpPr txBox="1"/>
          <p:nvPr/>
        </p:nvSpPr>
        <p:spPr>
          <a:xfrm>
            <a:off x="1354925" y="4682856"/>
            <a:ext cx="17002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0000"/>
                </a:solidFill>
              </a:rPr>
              <a:t>PF </a:t>
            </a:r>
            <a:r>
              <a:rPr lang="en-GB" sz="1000" b="1" dirty="0"/>
              <a:t>+</a:t>
            </a:r>
            <a:r>
              <a:rPr lang="en-GB" sz="1000" b="1" dirty="0">
                <a:solidFill>
                  <a:srgbClr val="FF0000"/>
                </a:solidFill>
              </a:rPr>
              <a:t> PR                         </a:t>
            </a:r>
            <a:r>
              <a:rPr lang="en-GB" sz="1000" b="1" dirty="0">
                <a:solidFill>
                  <a:srgbClr val="00B050"/>
                </a:solidFill>
              </a:rPr>
              <a:t>G  </a:t>
            </a:r>
            <a:r>
              <a:rPr lang="en-GB" sz="1000" b="1" dirty="0"/>
              <a:t>+ </a:t>
            </a:r>
            <a:r>
              <a:rPr lang="en-GB" sz="1000" b="1" dirty="0">
                <a:solidFill>
                  <a:srgbClr val="FF0000"/>
                </a:solidFill>
              </a:rPr>
              <a:t>PF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6DC6B2B-21C5-C72F-DB73-1353EFDA44A1}"/>
              </a:ext>
            </a:extLst>
          </p:cNvPr>
          <p:cNvCxnSpPr/>
          <p:nvPr/>
        </p:nvCxnSpPr>
        <p:spPr>
          <a:xfrm>
            <a:off x="1297455" y="4916209"/>
            <a:ext cx="6769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7CF3122-79F4-8BF0-E1D0-88B145F1FACE}"/>
              </a:ext>
            </a:extLst>
          </p:cNvPr>
          <p:cNvCxnSpPr/>
          <p:nvPr/>
        </p:nvCxnSpPr>
        <p:spPr>
          <a:xfrm>
            <a:off x="2378224" y="4916209"/>
            <a:ext cx="6769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2D5F451-CD0E-AB53-F2B3-ABACB15F40E5}"/>
              </a:ext>
            </a:extLst>
          </p:cNvPr>
          <p:cNvSpPr txBox="1"/>
          <p:nvPr/>
        </p:nvSpPr>
        <p:spPr>
          <a:xfrm>
            <a:off x="642032" y="2748357"/>
            <a:ext cx="384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022BF8C-09F0-8902-BFC0-373F53C1DB5A}"/>
              </a:ext>
            </a:extLst>
          </p:cNvPr>
          <p:cNvSpPr txBox="1"/>
          <p:nvPr/>
        </p:nvSpPr>
        <p:spPr>
          <a:xfrm>
            <a:off x="4413183" y="4779352"/>
            <a:ext cx="384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AE81AA6-3DDC-0EBC-3399-A70CFD657B04}"/>
              </a:ext>
            </a:extLst>
          </p:cNvPr>
          <p:cNvSpPr txBox="1"/>
          <p:nvPr/>
        </p:nvSpPr>
        <p:spPr>
          <a:xfrm>
            <a:off x="4844663" y="4507561"/>
            <a:ext cx="761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0000"/>
                </a:solidFill>
              </a:rPr>
              <a:t> </a:t>
            </a:r>
            <a:r>
              <a:rPr lang="en-GB" sz="1000" b="1" dirty="0"/>
              <a:t>35S</a:t>
            </a:r>
            <a:r>
              <a:rPr lang="en-GB" sz="1000" b="1" dirty="0">
                <a:solidFill>
                  <a:srgbClr val="00B050"/>
                </a:solidFill>
              </a:rPr>
              <a:t> </a:t>
            </a:r>
            <a:r>
              <a:rPr lang="en-GB" sz="1000" b="1" dirty="0"/>
              <a:t>+</a:t>
            </a:r>
            <a:r>
              <a:rPr lang="en-GB" sz="1000" b="1" dirty="0">
                <a:solidFill>
                  <a:srgbClr val="00B050"/>
                </a:solidFill>
              </a:rPr>
              <a:t> </a:t>
            </a:r>
            <a:r>
              <a:rPr lang="en-GB" sz="1000" b="1" dirty="0">
                <a:solidFill>
                  <a:schemeClr val="accent1">
                    <a:lumMod val="75000"/>
                  </a:schemeClr>
                </a:solidFill>
              </a:rPr>
              <a:t>CR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6AB567D-2F41-2C3E-55F8-86E052FB0DED}"/>
              </a:ext>
            </a:extLst>
          </p:cNvPr>
          <p:cNvCxnSpPr>
            <a:cxnSpLocks/>
          </p:cNvCxnSpPr>
          <p:nvPr/>
        </p:nvCxnSpPr>
        <p:spPr>
          <a:xfrm>
            <a:off x="4929387" y="4740914"/>
            <a:ext cx="6769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ABC1A07F-CB7F-4FF8-7E92-A9B11291CC91}"/>
              </a:ext>
            </a:extLst>
          </p:cNvPr>
          <p:cNvSpPr txBox="1"/>
          <p:nvPr/>
        </p:nvSpPr>
        <p:spPr>
          <a:xfrm rot="16200000">
            <a:off x="5020716" y="4836899"/>
            <a:ext cx="461803" cy="605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r>
              <a:rPr lang="en-GB" sz="1000" b="1" dirty="0"/>
              <a:t>OEX</a:t>
            </a:r>
          </a:p>
          <a:p>
            <a:pPr>
              <a:spcBef>
                <a:spcPts val="200"/>
              </a:spcBef>
            </a:pPr>
            <a:r>
              <a:rPr lang="en-GB" sz="1000" b="1" dirty="0"/>
              <a:t>OEX</a:t>
            </a:r>
          </a:p>
          <a:p>
            <a:pPr>
              <a:spcBef>
                <a:spcPts val="200"/>
              </a:spcBef>
            </a:pPr>
            <a:r>
              <a:rPr lang="en-GB" sz="1000" b="1" dirty="0"/>
              <a:t>W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DE0DD9-F991-20F3-D813-5500D102E9F9}"/>
              </a:ext>
            </a:extLst>
          </p:cNvPr>
          <p:cNvSpPr txBox="1"/>
          <p:nvPr/>
        </p:nvSpPr>
        <p:spPr>
          <a:xfrm>
            <a:off x="914491" y="551819"/>
            <a:ext cx="5077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3G23240; GK-850A03/N481507 and ERF-OEX N6143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7A1B93F-11B6-4805-4156-B7C9539B1CC6}"/>
              </a:ext>
            </a:extLst>
          </p:cNvPr>
          <p:cNvSpPr/>
          <p:nvPr/>
        </p:nvSpPr>
        <p:spPr>
          <a:xfrm>
            <a:off x="2667779" y="2248513"/>
            <a:ext cx="2409318" cy="1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5" name="Picture 44" descr="Text, calendar&#10;&#10;Description automatically generated">
            <a:extLst>
              <a:ext uri="{FF2B5EF4-FFF2-40B4-BE49-F238E27FC236}">
                <a16:creationId xmlns:a16="http://schemas.microsoft.com/office/drawing/2014/main" id="{4B321F6E-78F0-DADC-3004-366012533FE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52" t="11029" r="39381" b="14990"/>
          <a:stretch/>
        </p:blipFill>
        <p:spPr>
          <a:xfrm rot="5400000">
            <a:off x="1541701" y="2292665"/>
            <a:ext cx="1453904" cy="2719254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5DE08D4B-BCFD-D3DC-1664-ED2F8162117B}"/>
              </a:ext>
            </a:extLst>
          </p:cNvPr>
          <p:cNvSpPr txBox="1"/>
          <p:nvPr/>
        </p:nvSpPr>
        <p:spPr>
          <a:xfrm>
            <a:off x="1367513" y="2981709"/>
            <a:ext cx="21350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rabicPlain" startAt="33"/>
            </a:pPr>
            <a:r>
              <a:rPr lang="en-GB" sz="1000" dirty="0"/>
              <a:t>33 </a:t>
            </a:r>
          </a:p>
          <a:p>
            <a:r>
              <a:rPr lang="en-GB" sz="1000" dirty="0"/>
              <a:t>5.2     5.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C95720D-4A8D-AEA6-9EEC-EECC84EA233E}"/>
              </a:ext>
            </a:extLst>
          </p:cNvPr>
          <p:cNvSpPr txBox="1"/>
          <p:nvPr/>
        </p:nvSpPr>
        <p:spPr>
          <a:xfrm>
            <a:off x="1392000" y="2659508"/>
            <a:ext cx="57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FF0000"/>
                </a:solidFill>
              </a:rPr>
              <a:t>PF </a:t>
            </a:r>
            <a:r>
              <a:rPr lang="en-GB" sz="1000" b="1" dirty="0"/>
              <a:t>+</a:t>
            </a:r>
            <a:r>
              <a:rPr lang="en-GB" sz="1000" b="1" dirty="0">
                <a:solidFill>
                  <a:srgbClr val="FF0000"/>
                </a:solidFill>
              </a:rPr>
              <a:t> PR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149D2719-73E7-F605-115F-83FD38C88BBE}"/>
              </a:ext>
            </a:extLst>
          </p:cNvPr>
          <p:cNvCxnSpPr>
            <a:cxnSpLocks/>
          </p:cNvCxnSpPr>
          <p:nvPr/>
        </p:nvCxnSpPr>
        <p:spPr>
          <a:xfrm>
            <a:off x="1426125" y="2903079"/>
            <a:ext cx="54055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85593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334C0DEE-01FE-2B70-4558-5B23AE4224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7248804" y="2703125"/>
            <a:ext cx="52255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1 co-expression analysis of </a:t>
            </a:r>
            <a:r>
              <a:rPr kumimoji="0" lang="en-GB" altLang="en-US" sz="1200" b="1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21</a:t>
            </a:r>
            <a:r>
              <a:rPr kumimoji="0" lang="en-GB" altLang="en-US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TFs during (A) development (B) under environmental stress (C) biotic stress (D) hormone treatment in PlantPAN3.0</a:t>
            </a:r>
            <a:endParaRPr kumimoji="0" lang="en-GB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086B0F0-831C-E374-74DE-586B8C8D6E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6990" y="764275"/>
            <a:ext cx="4151136" cy="90062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7493D07-EDB4-04B5-D841-4D7D1E8AA02F}"/>
              </a:ext>
            </a:extLst>
          </p:cNvPr>
          <p:cNvSpPr txBox="1"/>
          <p:nvPr/>
        </p:nvSpPr>
        <p:spPr>
          <a:xfrm>
            <a:off x="382137" y="244643"/>
            <a:ext cx="6475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Table 1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o-expression analysis of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AG21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th TFs during (A) development (B) under environmental stress (C) biotic stress (D) hormone treatment in PlantPAN3.0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6069909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2E7815A-03EE-42EC-85B6-A329C023F5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8790473"/>
              </p:ext>
            </p:extLst>
          </p:nvPr>
        </p:nvGraphicFramePr>
        <p:xfrm>
          <a:off x="883692" y="1395793"/>
          <a:ext cx="5090615" cy="7114413"/>
        </p:xfrm>
        <a:graphic>
          <a:graphicData uri="http://schemas.openxmlformats.org/drawingml/2006/table">
            <a:tbl>
              <a:tblPr firstRow="1" firstCol="1" bandRow="1"/>
              <a:tblGrid>
                <a:gridCol w="1187396">
                  <a:extLst>
                    <a:ext uri="{9D8B030D-6E8A-4147-A177-3AD203B41FA5}">
                      <a16:colId xmlns:a16="http://schemas.microsoft.com/office/drawing/2014/main" val="2177697771"/>
                    </a:ext>
                  </a:extLst>
                </a:gridCol>
                <a:gridCol w="591158">
                  <a:extLst>
                    <a:ext uri="{9D8B030D-6E8A-4147-A177-3AD203B41FA5}">
                      <a16:colId xmlns:a16="http://schemas.microsoft.com/office/drawing/2014/main" val="1236105973"/>
                    </a:ext>
                  </a:extLst>
                </a:gridCol>
                <a:gridCol w="637456">
                  <a:extLst>
                    <a:ext uri="{9D8B030D-6E8A-4147-A177-3AD203B41FA5}">
                      <a16:colId xmlns:a16="http://schemas.microsoft.com/office/drawing/2014/main" val="3301528648"/>
                    </a:ext>
                  </a:extLst>
                </a:gridCol>
                <a:gridCol w="2674605">
                  <a:extLst>
                    <a:ext uri="{9D8B030D-6E8A-4147-A177-3AD203B41FA5}">
                      <a16:colId xmlns:a16="http://schemas.microsoft.com/office/drawing/2014/main" val="8689589"/>
                    </a:ext>
                  </a:extLst>
                </a:gridCol>
              </a:tblGrid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st of TFs that bind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xpt No.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F family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issue/treatment tested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772571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SOC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5846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pices, flowering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44441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P2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301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P2/E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46651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SVP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3120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18491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RGA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926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 apice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021009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JAG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537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2H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 tips (only unopened buds)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45878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HY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9425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S-F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,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9768723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P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987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072959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SEP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6987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florescence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15226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WRKY33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289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RKY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eaves, upon Botrytis cinerea 2100 inoculation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540328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ERF115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79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oot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6218365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LFY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568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FY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mplete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346591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REV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672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D-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days old seedling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604270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PIF4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5315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tiolated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437034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TOC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595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R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760291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LM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08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edlings, flowering and temperature dependenc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0494165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PhyA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770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S-F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 days old seedling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2574857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IBH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120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edlings BZ signal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555013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BBM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2400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P2/E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embryogenic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911499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HY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08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S-F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 days old seedling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85005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DELLA 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187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days old whole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6646823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BI5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14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811202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MYB3R3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055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Y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907501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CCA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53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Y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 days old whole seedlings,  circadian?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541169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SFA1A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935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S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edling, in response to temperature increa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9813468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ZF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448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2H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 hrs old plant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967876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IE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448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D40-lik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 hrs old plant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2562401"/>
                  </a:ext>
                </a:extLst>
              </a:tr>
              <a:tr h="1957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BZIP28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4146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 days old seedlings, Unfolded Protein Response in Maintaining Fertility upon Heat Stres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012264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IE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56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D40-lik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 hrs old plant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984415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BF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224616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BF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561615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BF4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201403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NAC03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C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318549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ANAC10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C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92623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DIV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Y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76417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DREB2A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P2/E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8835293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FBH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99916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GBF2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0880357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GBF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6148253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AT22 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D-ZI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015121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B5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0870577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B6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253734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B7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463687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HSFA6A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S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3670910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MYB3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Y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39035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MYB44 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Y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721448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NFYB2 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FY-B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7896966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NFYC2  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FY-C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4901031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AC07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C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160765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ZAT6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056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2H2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ABA response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0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2127224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CRY2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19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S-FRF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in limiting blue light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159728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PIF4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19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in limiting blue light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364332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PIF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283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skotomorphogenesi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136059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PIF4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284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HLH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hole seedlings, skotomorphogenesi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8911818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LEC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9587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F-Y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ent cotyledon stage seeds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0710368"/>
                  </a:ext>
                </a:extLst>
              </a:tr>
              <a:tr h="1107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 KAN1   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081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RP</a:t>
                      </a:r>
                      <a:endParaRPr lang="en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unknown</a:t>
                      </a:r>
                      <a:endParaRPr lang="en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102" marR="4210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556002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A9BFFDD-5F27-5820-FBD7-94781CE59392}"/>
              </a:ext>
            </a:extLst>
          </p:cNvPr>
          <p:cNvSpPr txBox="1"/>
          <p:nvPr/>
        </p:nvSpPr>
        <p:spPr>
          <a:xfrm>
            <a:off x="883692" y="788100"/>
            <a:ext cx="50906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2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Fs identified in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eriments as binding to the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moter in PlantPAN3.0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2391408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585FF33-8815-F2A6-E73C-C93A3030C2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1658029"/>
              </p:ext>
            </p:extLst>
          </p:nvPr>
        </p:nvGraphicFramePr>
        <p:xfrm>
          <a:off x="1585967" y="1681492"/>
          <a:ext cx="3686066" cy="7492587"/>
        </p:xfrm>
        <a:graphic>
          <a:graphicData uri="http://schemas.openxmlformats.org/drawingml/2006/table">
            <a:tbl>
              <a:tblPr/>
              <a:tblGrid>
                <a:gridCol w="771030">
                  <a:extLst>
                    <a:ext uri="{9D8B030D-6E8A-4147-A177-3AD203B41FA5}">
                      <a16:colId xmlns:a16="http://schemas.microsoft.com/office/drawing/2014/main" val="1529098970"/>
                    </a:ext>
                  </a:extLst>
                </a:gridCol>
                <a:gridCol w="892772">
                  <a:extLst>
                    <a:ext uri="{9D8B030D-6E8A-4147-A177-3AD203B41FA5}">
                      <a16:colId xmlns:a16="http://schemas.microsoft.com/office/drawing/2014/main" val="1716234878"/>
                    </a:ext>
                  </a:extLst>
                </a:gridCol>
                <a:gridCol w="1095675">
                  <a:extLst>
                    <a:ext uri="{9D8B030D-6E8A-4147-A177-3AD203B41FA5}">
                      <a16:colId xmlns:a16="http://schemas.microsoft.com/office/drawing/2014/main" val="3715492444"/>
                    </a:ext>
                  </a:extLst>
                </a:gridCol>
                <a:gridCol w="926589">
                  <a:extLst>
                    <a:ext uri="{9D8B030D-6E8A-4147-A177-3AD203B41FA5}">
                      <a16:colId xmlns:a16="http://schemas.microsoft.com/office/drawing/2014/main" val="1771271037"/>
                    </a:ext>
                  </a:extLst>
                </a:gridCol>
              </a:tblGrid>
              <a:tr h="10652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AT code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F name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F family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interaction tested *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65792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775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2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285523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795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L1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-HOOK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863099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294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L16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-HOOK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5237866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455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AA 1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x/IAA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20238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1516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NQUO 2, 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HLH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579351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710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IF 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HLH147-RELATED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53805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929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F 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5213947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0112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BZIP54 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505562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890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29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2309537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627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BF 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0732165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693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-type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1142653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27730 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T1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600380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276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 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P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101504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024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B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7430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10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DOF 4.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o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02562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022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I 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91363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13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057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77184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11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07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921175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324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5161473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380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391984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437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5700767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12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829189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4722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6238188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472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495688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2539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INE 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68071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6189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1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361339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6978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1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18227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661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2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6336266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175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ML 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499963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9840.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 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008850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779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T 2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92429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31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687895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398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5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720785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336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G1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9210736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611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9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550245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166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1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776906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407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A9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507849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1014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C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KC-MADS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339902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08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F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KC-MADS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3765738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0168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 5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847281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272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 67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3871008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268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85 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25699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635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D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-related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677292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244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8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C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605333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379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2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C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7289443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454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7616201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706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8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320774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0115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A2B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NG-H2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71166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810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 8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3845969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762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4399780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6969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5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28674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515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6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1921506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191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9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963817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7010 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2497014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3556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0823423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323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0950326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5030.1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4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4828428"/>
                  </a:ext>
                </a:extLst>
              </a:tr>
              <a:tr h="10652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39760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 23</a:t>
                      </a:r>
                    </a:p>
                  </a:txBody>
                  <a:tcPr marL="5073" marR="5073" marT="50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F-HD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5073" marR="5073" marT="50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23584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C28D023-24E5-02D5-D63C-69D6BD4445BB}"/>
              </a:ext>
            </a:extLst>
          </p:cNvPr>
          <p:cNvSpPr txBox="1"/>
          <p:nvPr/>
        </p:nvSpPr>
        <p:spPr>
          <a:xfrm>
            <a:off x="979226" y="1035161"/>
            <a:ext cx="50906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3A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l TFs binding to the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moter in the primary Y1H screen of 1500 TFs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8970A1-42C0-C6F2-1547-024B936EC615}"/>
              </a:ext>
            </a:extLst>
          </p:cNvPr>
          <p:cNvSpPr txBox="1"/>
          <p:nvPr/>
        </p:nvSpPr>
        <p:spPr>
          <a:xfrm>
            <a:off x="1484193" y="9174079"/>
            <a:ext cx="3920319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b="0" i="0" u="none" strike="noStrike" dirty="0">
                <a:solidFill>
                  <a:srgbClr val="000000"/>
                </a:solidFill>
                <a:effectLst/>
              </a:rPr>
              <a:t>* all interactions that were re- tested through one on one Y1H are shaded green: those that were verified are marked "Y" and those that were not confirmed are marked "N"</a:t>
            </a:r>
            <a:r>
              <a:rPr lang="en-GB" sz="9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28645212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D67A2AD-4C93-6D8B-FD61-597915E285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9642411"/>
              </p:ext>
            </p:extLst>
          </p:nvPr>
        </p:nvGraphicFramePr>
        <p:xfrm>
          <a:off x="706272" y="848983"/>
          <a:ext cx="5445456" cy="8231662"/>
        </p:xfrm>
        <a:graphic>
          <a:graphicData uri="http://schemas.openxmlformats.org/drawingml/2006/table">
            <a:tbl>
              <a:tblPr/>
              <a:tblGrid>
                <a:gridCol w="689837">
                  <a:extLst>
                    <a:ext uri="{9D8B030D-6E8A-4147-A177-3AD203B41FA5}">
                      <a16:colId xmlns:a16="http://schemas.microsoft.com/office/drawing/2014/main" val="280248440"/>
                    </a:ext>
                  </a:extLst>
                </a:gridCol>
                <a:gridCol w="1030028">
                  <a:extLst>
                    <a:ext uri="{9D8B030D-6E8A-4147-A177-3AD203B41FA5}">
                      <a16:colId xmlns:a16="http://schemas.microsoft.com/office/drawing/2014/main" val="2680563866"/>
                    </a:ext>
                  </a:extLst>
                </a:gridCol>
                <a:gridCol w="928444">
                  <a:extLst>
                    <a:ext uri="{9D8B030D-6E8A-4147-A177-3AD203B41FA5}">
                      <a16:colId xmlns:a16="http://schemas.microsoft.com/office/drawing/2014/main" val="101190599"/>
                    </a:ext>
                  </a:extLst>
                </a:gridCol>
                <a:gridCol w="973331">
                  <a:extLst>
                    <a:ext uri="{9D8B030D-6E8A-4147-A177-3AD203B41FA5}">
                      <a16:colId xmlns:a16="http://schemas.microsoft.com/office/drawing/2014/main" val="2501005703"/>
                    </a:ext>
                  </a:extLst>
                </a:gridCol>
                <a:gridCol w="907183">
                  <a:extLst>
                    <a:ext uri="{9D8B030D-6E8A-4147-A177-3AD203B41FA5}">
                      <a16:colId xmlns:a16="http://schemas.microsoft.com/office/drawing/2014/main" val="3507559029"/>
                    </a:ext>
                  </a:extLst>
                </a:gridCol>
                <a:gridCol w="916633">
                  <a:extLst>
                    <a:ext uri="{9D8B030D-6E8A-4147-A177-3AD203B41FA5}">
                      <a16:colId xmlns:a16="http://schemas.microsoft.com/office/drawing/2014/main" val="2516184395"/>
                    </a:ext>
                  </a:extLst>
                </a:gridCol>
              </a:tblGrid>
              <a:tr h="28647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romoter fragment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AT code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F name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F family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interaction verified*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Additional interactions revealed by Y1H verificatio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591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752146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437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113840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1 to -333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27730 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T10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249462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355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38888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32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662932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810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8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606411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696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05385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12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484797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50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56219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32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842374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70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0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56643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515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6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30246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762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34958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775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441204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1516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NQUO 2, 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HLH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073168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355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T10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631234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178 to -479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3230 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228088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6969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09170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61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895049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50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587181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32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984184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7010 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20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081365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515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6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508916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4762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9010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0112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BZIP54 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521275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02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B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074988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26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85 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03764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19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1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97277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437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4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295341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411 to -734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697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1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8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3844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61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5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954176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9840.2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 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1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571398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66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2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13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55081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29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L16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-HOOK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999251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227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 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P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556372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618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1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932686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795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L1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-HOOK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66476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26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85 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459765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397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2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F-HD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85518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39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5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085623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611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B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G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5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856763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645 to -962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9840.2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 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4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027069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29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HL 16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-HOOK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23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13252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710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IF 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HLH147-RELATED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95803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175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ML1 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718615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77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T 2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516457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3976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 2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F-HD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546429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929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F 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7610690"/>
                  </a:ext>
                </a:extLst>
              </a:tr>
              <a:tr h="13278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893 to -1221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10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DOF 4.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o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1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610024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175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ML 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13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62545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890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2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23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950622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69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-type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H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339807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11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070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429317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380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0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994761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0437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236417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12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277720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4722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663755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472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26399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627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BF 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158984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618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HB1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190654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31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B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400364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733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G1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-ZI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98293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635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D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-related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83721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166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11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742087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5407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A9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479385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455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AA 1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x/IAA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034319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1014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C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KC-MADS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473121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0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F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KC-MADS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5296797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016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 5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605492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272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 67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5676706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37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2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C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205351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2443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8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C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350025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1454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9069288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3706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8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-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0787105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0115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A2B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NG-H2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402914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2539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INE 3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71013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50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 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49014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8100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 8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771739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5G651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057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3882543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1G5810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 8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703793"/>
                  </a:ext>
                </a:extLst>
              </a:tr>
              <a:tr h="132789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-1126 to -1436)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2G4022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I 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583941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3G1503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4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P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825840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2268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 8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B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3570162"/>
                  </a:ext>
                </a:extLst>
              </a:tr>
              <a:tr h="70776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1060.1</a:t>
                      </a:r>
                    </a:p>
                  </a:txBody>
                  <a:tcPr marL="3370" marR="3370" marT="33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15</a:t>
                      </a:r>
                    </a:p>
                  </a:txBody>
                  <a:tcPr marL="3370" marR="3370" marT="33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F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0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370" marR="3370" marT="33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290244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B4D1ED3-ED16-C351-43E7-A1D39BB06F56}"/>
              </a:ext>
            </a:extLst>
          </p:cNvPr>
          <p:cNvSpPr txBox="1"/>
          <p:nvPr/>
        </p:nvSpPr>
        <p:spPr>
          <a:xfrm>
            <a:off x="706272" y="202652"/>
            <a:ext cx="50906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3B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ocation of binding in the SAG21 promoter of all TFs identified in the primary Y1H screen of 1500 TFs</a:t>
            </a:r>
            <a:endParaRPr lang="en-GB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5330F5-E261-1F15-7B9E-6EEFD7ED4665}"/>
              </a:ext>
            </a:extLst>
          </p:cNvPr>
          <p:cNvSpPr txBox="1"/>
          <p:nvPr/>
        </p:nvSpPr>
        <p:spPr>
          <a:xfrm>
            <a:off x="706272" y="9241683"/>
            <a:ext cx="544545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/>
              <a:t>* all interactions that were re- tested through one on one Y1H are shaded green: those that were verified are marked "Y" and those that were not confirmed are marked "N"</a:t>
            </a:r>
          </a:p>
        </p:txBody>
      </p:sp>
    </p:spTree>
    <p:extLst>
      <p:ext uri="{BB962C8B-B14F-4D97-AF65-F5344CB8AC3E}">
        <p14:creationId xmlns:p14="http://schemas.microsoft.com/office/powerpoint/2010/main" val="17430931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9FBF45E-FC5F-E0FC-7DED-E5A234BAA8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7640" y="1224045"/>
            <a:ext cx="4662720" cy="74579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78554BD-3699-23C8-903E-BE802DA61792}"/>
              </a:ext>
            </a:extLst>
          </p:cNvPr>
          <p:cNvSpPr txBox="1"/>
          <p:nvPr/>
        </p:nvSpPr>
        <p:spPr>
          <a:xfrm>
            <a:off x="992874" y="741360"/>
            <a:ext cx="34324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4: </a:t>
            </a:r>
            <a:r>
              <a:rPr lang="en-GB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l PCR primers used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67065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8AD543C-AF12-A4D0-F286-00EC4613DE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2491701"/>
              </p:ext>
            </p:extLst>
          </p:nvPr>
        </p:nvGraphicFramePr>
        <p:xfrm>
          <a:off x="471487" y="2054943"/>
          <a:ext cx="5915025" cy="2289847"/>
        </p:xfrm>
        <a:graphic>
          <a:graphicData uri="http://schemas.openxmlformats.org/drawingml/2006/table">
            <a:tbl>
              <a:tblPr/>
              <a:tblGrid>
                <a:gridCol w="327759">
                  <a:extLst>
                    <a:ext uri="{9D8B030D-6E8A-4147-A177-3AD203B41FA5}">
                      <a16:colId xmlns:a16="http://schemas.microsoft.com/office/drawing/2014/main" val="2264359764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31972708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2554858149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3856123160"/>
                    </a:ext>
                  </a:extLst>
                </a:gridCol>
                <a:gridCol w="689660">
                  <a:extLst>
                    <a:ext uri="{9D8B030D-6E8A-4147-A177-3AD203B41FA5}">
                      <a16:colId xmlns:a16="http://schemas.microsoft.com/office/drawing/2014/main" val="712313007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2426933621"/>
                    </a:ext>
                  </a:extLst>
                </a:gridCol>
                <a:gridCol w="621376">
                  <a:extLst>
                    <a:ext uri="{9D8B030D-6E8A-4147-A177-3AD203B41FA5}">
                      <a16:colId xmlns:a16="http://schemas.microsoft.com/office/drawing/2014/main" val="1335746262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775432169"/>
                    </a:ext>
                  </a:extLst>
                </a:gridCol>
                <a:gridCol w="445547">
                  <a:extLst>
                    <a:ext uri="{9D8B030D-6E8A-4147-A177-3AD203B41FA5}">
                      <a16:colId xmlns:a16="http://schemas.microsoft.com/office/drawing/2014/main" val="2185638504"/>
                    </a:ext>
                  </a:extLst>
                </a:gridCol>
                <a:gridCol w="525780">
                  <a:extLst>
                    <a:ext uri="{9D8B030D-6E8A-4147-A177-3AD203B41FA5}">
                      <a16:colId xmlns:a16="http://schemas.microsoft.com/office/drawing/2014/main" val="2211945372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3751969201"/>
                    </a:ext>
                  </a:extLst>
                </a:gridCol>
                <a:gridCol w="327759">
                  <a:extLst>
                    <a:ext uri="{9D8B030D-6E8A-4147-A177-3AD203B41FA5}">
                      <a16:colId xmlns:a16="http://schemas.microsoft.com/office/drawing/2014/main" val="3667609491"/>
                    </a:ext>
                  </a:extLst>
                </a:gridCol>
                <a:gridCol w="1010590">
                  <a:extLst>
                    <a:ext uri="{9D8B030D-6E8A-4147-A177-3AD203B41FA5}">
                      <a16:colId xmlns:a16="http://schemas.microsoft.com/office/drawing/2014/main" val="325854197"/>
                    </a:ext>
                  </a:extLst>
                </a:gridCol>
              </a:tblGrid>
              <a:tr h="102454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C TFs:</a:t>
                      </a: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57820"/>
                  </a:ext>
                </a:extLst>
              </a:tr>
              <a:tr h="107577">
                <a:tc>
                  <a:txBody>
                    <a:bodyPr/>
                    <a:lstStyle/>
                    <a:p>
                      <a:pPr algn="l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3296221"/>
                  </a:ext>
                </a:extLst>
              </a:tr>
              <a:tr h="169049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8/ANAC03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L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0234729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sed NAC AT1G0221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3907428"/>
                  </a:ext>
                </a:extLst>
              </a:tr>
              <a:tr h="169049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1/ANAC05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9/ANAC08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sed NAC AT1G1904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303028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sed NAC AT1G6030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0550574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1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sed NAC AT1G6038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774680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4/ANAC03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2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3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sed NAC AT3G1291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9256751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0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4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P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4455605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t"/>
                      <a:r>
                        <a:rPr lang="en-GB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0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19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2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3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4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57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68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7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86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09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C105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mpty</a:t>
                      </a:r>
                    </a:p>
                  </a:txBody>
                  <a:tcPr marL="5123" marR="5123" marT="512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499758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5579073"/>
                  </a:ext>
                </a:extLst>
              </a:tr>
              <a:tr h="102454"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 TFs</a:t>
                      </a:r>
                    </a:p>
                  </a:txBody>
                  <a:tcPr marL="5123" marR="5123" marT="512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1685637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5432941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FP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0887525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mpty vector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1877337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7662332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7161937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6742547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5976643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6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3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1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7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378567"/>
                  </a:ext>
                </a:extLst>
              </a:tr>
              <a:tr h="102454"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9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18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2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35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44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52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RKY67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4G30930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23" marR="5123" marT="51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42205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2FC7577-FA89-4DEC-B410-FEE1E5E470B7}"/>
              </a:ext>
            </a:extLst>
          </p:cNvPr>
          <p:cNvSpPr txBox="1"/>
          <p:nvPr/>
        </p:nvSpPr>
        <p:spPr>
          <a:xfrm>
            <a:off x="351430" y="1312544"/>
            <a:ext cx="6035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5 - </a:t>
            </a:r>
            <a:r>
              <a:rPr lang="en-GB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C and WRKY  TFs included in the yeast-1-hybrid scree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77739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226FC31-B98D-455C-BD82-B297EAEE2F2A}"/>
              </a:ext>
            </a:extLst>
          </p:cNvPr>
          <p:cNvPicPr>
            <a:picLocks noChangeAspect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655" y="705701"/>
            <a:ext cx="5478570" cy="1073134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801D97C-7309-4FCF-8C24-8D86A16D5205}"/>
              </a:ext>
            </a:extLst>
          </p:cNvPr>
          <p:cNvSpPr txBox="1"/>
          <p:nvPr/>
        </p:nvSpPr>
        <p:spPr>
          <a:xfrm>
            <a:off x="548167" y="4832865"/>
            <a:ext cx="595045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SAG21LTF </a:t>
            </a:r>
            <a:r>
              <a:rPr lang="en-GB" sz="900" b="1" dirty="0"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GACGCAGCCGTTTATGAG</a:t>
            </a:r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   Tm = 62.1˚C   </a:t>
            </a:r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AG21RTF </a:t>
            </a:r>
            <a:r>
              <a:rPr lang="en-GB" sz="900" b="1" dirty="0">
                <a:solidFill>
                  <a:srgbClr val="00B05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AAGAAGTGGAGCTGTTG</a:t>
            </a:r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Tm = 52.6˚C</a:t>
            </a:r>
          </a:p>
          <a:p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SAG21LTR </a:t>
            </a:r>
            <a:r>
              <a:rPr lang="en-GB" sz="900" b="1" dirty="0">
                <a:solidFill>
                  <a:srgbClr val="0000FF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CTCGAAACGCTCCCTTG</a:t>
            </a:r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    Tm = 62.2˚C   SAG21RTR </a:t>
            </a:r>
            <a:r>
              <a:rPr lang="en-GB" sz="900" b="1" dirty="0">
                <a:solidFill>
                  <a:srgbClr val="00B05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TGCTTGTTGTTCAAGAGAG</a:t>
            </a:r>
            <a:r>
              <a:rPr lang="en-GB" sz="900" dirty="0"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 Tm = 56.5˚C</a:t>
            </a:r>
          </a:p>
          <a:p>
            <a:r>
              <a:rPr lang="en-GB" sz="900" b="1" dirty="0">
                <a:latin typeface="Courier New" panose="02070309020205020404" pitchFamily="49" charset="0"/>
              </a:rPr>
              <a:t>514 bp with gDNA and 414 bp with cDNA       170 bp with gDNA and cDNA</a:t>
            </a:r>
          </a:p>
          <a:p>
            <a:endParaRPr lang="en-GB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SAG21NF </a:t>
            </a:r>
            <a:r>
              <a:rPr lang="en-GB" sz="900" b="1" dirty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TCGTTCTATCTCTAACG</a:t>
            </a: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Tm = 61.2 ˚C</a:t>
            </a:r>
          </a:p>
          <a:p>
            <a:r>
              <a:rPr lang="en-GB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216 bp with gDNA and 116 bp with cD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620363E-EF39-43A9-A51E-2624E6872952}"/>
              </a:ext>
            </a:extLst>
          </p:cNvPr>
          <p:cNvSpPr txBox="1"/>
          <p:nvPr/>
        </p:nvSpPr>
        <p:spPr>
          <a:xfrm rot="16200000">
            <a:off x="2035752" y="5498923"/>
            <a:ext cx="686847" cy="1195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900" b="1" dirty="0"/>
              <a:t>gDNA</a:t>
            </a:r>
            <a:endParaRPr lang="en-GB" sz="900" dirty="0"/>
          </a:p>
          <a:p>
            <a:pPr>
              <a:spcBef>
                <a:spcPts val="800"/>
              </a:spcBef>
            </a:pPr>
            <a:r>
              <a:rPr lang="en-GB" sz="900" b="1" dirty="0" err="1"/>
              <a:t>cDN</a:t>
            </a:r>
            <a:r>
              <a:rPr lang="en-GB" sz="900" b="1" dirty="0"/>
              <a:t>-AUS</a:t>
            </a:r>
          </a:p>
          <a:p>
            <a:pPr>
              <a:spcBef>
                <a:spcPts val="800"/>
              </a:spcBef>
            </a:pPr>
            <a:r>
              <a:rPr lang="en-GB" sz="900" b="1" dirty="0"/>
              <a:t>cDNA-SS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/>
              <a:t>cDNA-DS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ea typeface="Times New Roman" panose="02020603050405020304" pitchFamily="18" charset="0"/>
              </a:rPr>
              <a:t>negative</a:t>
            </a:r>
            <a:endParaRPr lang="en-GB" sz="900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1FF11C4-EE86-48AD-A30C-33E2D1B14CC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325" y="6361334"/>
            <a:ext cx="4093369" cy="307002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9A2CE59-C54C-4EA5-BE73-F1578AFB52D8}"/>
              </a:ext>
            </a:extLst>
          </p:cNvPr>
          <p:cNvSpPr txBox="1"/>
          <p:nvPr/>
        </p:nvSpPr>
        <p:spPr>
          <a:xfrm rot="16200000">
            <a:off x="4040289" y="5430988"/>
            <a:ext cx="822717" cy="1195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900" b="1" dirty="0"/>
              <a:t>gDNA</a:t>
            </a:r>
            <a:endParaRPr lang="en-GB" sz="900" dirty="0"/>
          </a:p>
          <a:p>
            <a:pPr>
              <a:spcBef>
                <a:spcPts val="800"/>
              </a:spcBef>
            </a:pPr>
            <a:r>
              <a:rPr lang="en-GB" sz="900" b="1" dirty="0"/>
              <a:t>cDNA-US</a:t>
            </a:r>
          </a:p>
          <a:p>
            <a:pPr>
              <a:spcBef>
                <a:spcPts val="800"/>
              </a:spcBef>
            </a:pPr>
            <a:r>
              <a:rPr lang="en-GB" sz="900" b="1" dirty="0"/>
              <a:t>cDNA-SS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/>
              <a:t>cDNA-DS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ea typeface="Times New Roman" panose="02020603050405020304" pitchFamily="18" charset="0"/>
              </a:rPr>
              <a:t>negative</a:t>
            </a:r>
            <a:endParaRPr lang="en-GB" sz="900" b="1" dirty="0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6FE2B41-2915-4D2E-83F8-83D78501BCDA}"/>
              </a:ext>
            </a:extLst>
          </p:cNvPr>
          <p:cNvCxnSpPr/>
          <p:nvPr/>
        </p:nvCxnSpPr>
        <p:spPr>
          <a:xfrm>
            <a:off x="3521078" y="6361334"/>
            <a:ext cx="0" cy="307002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F1DD8BD7-BD61-4F20-B4D3-F66F0845DB66}"/>
              </a:ext>
            </a:extLst>
          </p:cNvPr>
          <p:cNvSpPr/>
          <p:nvPr/>
        </p:nvSpPr>
        <p:spPr>
          <a:xfrm>
            <a:off x="3521078" y="7991475"/>
            <a:ext cx="2470147" cy="1571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18E124-E897-42F7-A118-16D241CE1565}"/>
              </a:ext>
            </a:extLst>
          </p:cNvPr>
          <p:cNvSpPr txBox="1"/>
          <p:nvPr/>
        </p:nvSpPr>
        <p:spPr>
          <a:xfrm>
            <a:off x="3591270" y="8148730"/>
            <a:ext cx="2579927" cy="1195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900" b="1" dirty="0"/>
              <a:t>gDNA </a:t>
            </a:r>
            <a:r>
              <a:rPr lang="en-GB" sz="900" dirty="0"/>
              <a:t>genomic DNA</a:t>
            </a:r>
          </a:p>
          <a:p>
            <a:pPr>
              <a:spcBef>
                <a:spcPts val="800"/>
              </a:spcBef>
            </a:pPr>
            <a:r>
              <a:rPr lang="en-GB" sz="900" b="1" dirty="0"/>
              <a:t>cDNA-US </a:t>
            </a:r>
            <a:r>
              <a:rPr lang="en-GB" sz="900" dirty="0"/>
              <a:t>seedling cDNA (unstressed)</a:t>
            </a:r>
          </a:p>
          <a:p>
            <a:pPr>
              <a:spcBef>
                <a:spcPts val="800"/>
              </a:spcBef>
            </a:pPr>
            <a:r>
              <a:rPr lang="en-GB" sz="900" b="1" dirty="0"/>
              <a:t>cDNA-SS </a:t>
            </a:r>
            <a:r>
              <a:rPr lang="en-GB" sz="900" dirty="0"/>
              <a:t>seedling cDNA (salt stressed)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/>
              <a:t>cDNA-DS </a:t>
            </a:r>
            <a:r>
              <a:rPr lang="en-GB" sz="900" dirty="0"/>
              <a:t>seedling cDNA (drought stressed)</a:t>
            </a:r>
            <a:endParaRPr lang="en-GB" sz="900" dirty="0"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ea typeface="Times New Roman" panose="02020603050405020304" pitchFamily="18" charset="0"/>
              </a:rPr>
              <a:t>Negative </a:t>
            </a:r>
            <a:r>
              <a:rPr lang="en-GB" sz="900" dirty="0">
                <a:ea typeface="Times New Roman" panose="02020603050405020304" pitchFamily="18" charset="0"/>
              </a:rPr>
              <a:t>control</a:t>
            </a:r>
            <a:endParaRPr lang="en-GB" sz="9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84756E-1292-45E2-8102-C601BF33D8C5}"/>
              </a:ext>
            </a:extLst>
          </p:cNvPr>
          <p:cNvSpPr txBox="1"/>
          <p:nvPr/>
        </p:nvSpPr>
        <p:spPr>
          <a:xfrm>
            <a:off x="243653" y="690684"/>
            <a:ext cx="557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EB7AF55-A81F-4D09-BD6D-9D3BE4800E6D}"/>
              </a:ext>
            </a:extLst>
          </p:cNvPr>
          <p:cNvSpPr txBox="1"/>
          <p:nvPr/>
        </p:nvSpPr>
        <p:spPr>
          <a:xfrm>
            <a:off x="243653" y="1742656"/>
            <a:ext cx="557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A874EB-D9AD-4064-B7E2-EBBBA9824237}"/>
              </a:ext>
            </a:extLst>
          </p:cNvPr>
          <p:cNvSpPr txBox="1"/>
          <p:nvPr/>
        </p:nvSpPr>
        <p:spPr>
          <a:xfrm>
            <a:off x="284639" y="6354818"/>
            <a:ext cx="557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07CA000-CFD9-4BC0-B5C1-90ECD7482E00}"/>
              </a:ext>
            </a:extLst>
          </p:cNvPr>
          <p:cNvSpPr txBox="1"/>
          <p:nvPr/>
        </p:nvSpPr>
        <p:spPr>
          <a:xfrm>
            <a:off x="1954799" y="6578906"/>
            <a:ext cx="11257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solidFill>
                  <a:srgbClr val="0000FF"/>
                </a:solidFill>
              </a:rPr>
              <a:t>SAG21 LTF/LT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3EABFBF-2666-4716-8FE6-C9DF7B177C2E}"/>
              </a:ext>
            </a:extLst>
          </p:cNvPr>
          <p:cNvSpPr txBox="1"/>
          <p:nvPr/>
        </p:nvSpPr>
        <p:spPr>
          <a:xfrm>
            <a:off x="1984377" y="8226435"/>
            <a:ext cx="10096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solidFill>
                  <a:srgbClr val="00B0F0"/>
                </a:solidFill>
              </a:rPr>
              <a:t>SAG21 F/R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379C9F9-DB5E-4214-9ADA-49BE7ED9B8B2}"/>
              </a:ext>
            </a:extLst>
          </p:cNvPr>
          <p:cNvSpPr txBox="1"/>
          <p:nvPr/>
        </p:nvSpPr>
        <p:spPr>
          <a:xfrm>
            <a:off x="4018551" y="6650959"/>
            <a:ext cx="11951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solidFill>
                  <a:srgbClr val="00B050"/>
                </a:solidFill>
              </a:rPr>
              <a:t>SAG21 RTF/RT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5DCD983-89C1-4418-8968-146114928E0C}"/>
              </a:ext>
            </a:extLst>
          </p:cNvPr>
          <p:cNvSpPr txBox="1"/>
          <p:nvPr/>
        </p:nvSpPr>
        <p:spPr>
          <a:xfrm>
            <a:off x="900982" y="7066434"/>
            <a:ext cx="5979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514 bp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AEDCED21-EECD-4F97-BC6E-8FF9D93812C8}"/>
              </a:ext>
            </a:extLst>
          </p:cNvPr>
          <p:cNvCxnSpPr/>
          <p:nvPr/>
        </p:nvCxnSpPr>
        <p:spPr>
          <a:xfrm>
            <a:off x="1380014" y="7181850"/>
            <a:ext cx="7731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Picture 28">
            <a:extLst>
              <a:ext uri="{FF2B5EF4-FFF2-40B4-BE49-F238E27FC236}">
                <a16:creationId xmlns:a16="http://schemas.microsoft.com/office/drawing/2014/main" id="{072F9146-DADF-4CDC-AF0E-B46C74C2FED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" r="26666" b="27265"/>
          <a:stretch/>
        </p:blipFill>
        <p:spPr>
          <a:xfrm>
            <a:off x="1448343" y="8105009"/>
            <a:ext cx="2072732" cy="1620015"/>
          </a:xfrm>
          <a:prstGeom prst="rect">
            <a:avLst/>
          </a:prstGeom>
        </p:spPr>
      </p:pic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FABA780-4E86-4E12-A770-89C15FADEACC}"/>
              </a:ext>
            </a:extLst>
          </p:cNvPr>
          <p:cNvCxnSpPr>
            <a:cxnSpLocks/>
          </p:cNvCxnSpPr>
          <p:nvPr/>
        </p:nvCxnSpPr>
        <p:spPr>
          <a:xfrm flipH="1">
            <a:off x="1043579" y="8105009"/>
            <a:ext cx="2974972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47FBDF7-DFDE-4CD5-90C6-6E4B8C183881}"/>
              </a:ext>
            </a:extLst>
          </p:cNvPr>
          <p:cNvSpPr txBox="1"/>
          <p:nvPr/>
        </p:nvSpPr>
        <p:spPr>
          <a:xfrm rot="16200000">
            <a:off x="2096078" y="7836263"/>
            <a:ext cx="686849" cy="1195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900" b="1" dirty="0">
                <a:solidFill>
                  <a:schemeClr val="bg2"/>
                </a:solidFill>
              </a:rPr>
              <a:t>gDNA</a:t>
            </a:r>
            <a:endParaRPr lang="en-GB" sz="900" dirty="0">
              <a:solidFill>
                <a:schemeClr val="bg2"/>
              </a:solidFill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solidFill>
                  <a:schemeClr val="bg2"/>
                </a:solidFill>
              </a:rPr>
              <a:t>cDNA-US</a:t>
            </a:r>
          </a:p>
          <a:p>
            <a:pPr>
              <a:spcBef>
                <a:spcPts val="800"/>
              </a:spcBef>
            </a:pPr>
            <a:r>
              <a:rPr lang="en-GB" sz="900" b="1" dirty="0">
                <a:solidFill>
                  <a:schemeClr val="bg2"/>
                </a:solidFill>
              </a:rPr>
              <a:t>cDNA-SS</a:t>
            </a:r>
            <a:endParaRPr lang="en-GB" sz="900" dirty="0">
              <a:solidFill>
                <a:schemeClr val="bg2"/>
              </a:solidFill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solidFill>
                  <a:schemeClr val="bg2"/>
                </a:solidFill>
              </a:rPr>
              <a:t>cDNA-DS</a:t>
            </a:r>
            <a:endParaRPr lang="en-GB" sz="900" dirty="0">
              <a:solidFill>
                <a:schemeClr val="bg2"/>
              </a:solidFill>
              <a:effectLst/>
              <a:ea typeface="Times New Roman" panose="02020603050405020304" pitchFamily="18" charset="0"/>
            </a:endParaRPr>
          </a:p>
          <a:p>
            <a:pPr>
              <a:spcBef>
                <a:spcPts val="800"/>
              </a:spcBef>
            </a:pPr>
            <a:r>
              <a:rPr lang="en-GB" sz="900" b="1" dirty="0">
                <a:solidFill>
                  <a:schemeClr val="bg2"/>
                </a:solidFill>
                <a:ea typeface="Times New Roman" panose="02020603050405020304" pitchFamily="18" charset="0"/>
              </a:rPr>
              <a:t>negative</a:t>
            </a:r>
            <a:endParaRPr lang="en-GB" sz="900" b="1" dirty="0">
              <a:solidFill>
                <a:schemeClr val="bg2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98E893F-2F98-4376-A4F4-129018BE1439}"/>
              </a:ext>
            </a:extLst>
          </p:cNvPr>
          <p:cNvSpPr txBox="1"/>
          <p:nvPr/>
        </p:nvSpPr>
        <p:spPr>
          <a:xfrm>
            <a:off x="1984377" y="9485161"/>
            <a:ext cx="11257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solidFill>
                  <a:srgbClr val="00B0F0"/>
                </a:solidFill>
              </a:rPr>
              <a:t>SAG21 NF/RTR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19D8EBE1-9C05-48BA-B914-CFAD70CE58E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268"/>
          <a:stretch/>
        </p:blipFill>
        <p:spPr>
          <a:xfrm>
            <a:off x="563245" y="2039394"/>
            <a:ext cx="5766816" cy="28066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29FB5D4-2E6B-3903-E58B-1F82D098AF75}"/>
              </a:ext>
            </a:extLst>
          </p:cNvPr>
          <p:cNvSpPr txBox="1"/>
          <p:nvPr/>
        </p:nvSpPr>
        <p:spPr>
          <a:xfrm>
            <a:off x="284639" y="320288"/>
            <a:ext cx="3429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effectLst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Figure S1</a:t>
            </a:r>
            <a:endParaRPr lang="en-GB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FDEA231-EC63-C6C6-2721-8FC3560A3CD8}"/>
              </a:ext>
            </a:extLst>
          </p:cNvPr>
          <p:cNvSpPr txBox="1"/>
          <p:nvPr/>
        </p:nvSpPr>
        <p:spPr>
          <a:xfrm>
            <a:off x="5945731" y="926101"/>
            <a:ext cx="53732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ORF (aa)</a:t>
            </a:r>
          </a:p>
          <a:p>
            <a:r>
              <a:rPr lang="en-GB" sz="800" dirty="0"/>
              <a:t>97</a:t>
            </a:r>
          </a:p>
          <a:p>
            <a:r>
              <a:rPr lang="en-GB" sz="800" dirty="0"/>
              <a:t>192</a:t>
            </a:r>
          </a:p>
          <a:p>
            <a:r>
              <a:rPr lang="en-GB" sz="800" dirty="0"/>
              <a:t>78</a:t>
            </a:r>
          </a:p>
        </p:txBody>
      </p:sp>
    </p:spTree>
    <p:extLst>
      <p:ext uri="{BB962C8B-B14F-4D97-AF65-F5344CB8AC3E}">
        <p14:creationId xmlns:p14="http://schemas.microsoft.com/office/powerpoint/2010/main" val="3107776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6901BF5-838F-4DEE-BE63-81DB129276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1554" y="737937"/>
            <a:ext cx="6256446" cy="36598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8250CFD-71CA-481E-899A-30AE1AD00052}"/>
              </a:ext>
            </a:extLst>
          </p:cNvPr>
          <p:cNvSpPr txBox="1"/>
          <p:nvPr/>
        </p:nvSpPr>
        <p:spPr>
          <a:xfrm>
            <a:off x="230079" y="368605"/>
            <a:ext cx="557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6BFB6D-6590-4637-8583-3D471706C954}"/>
              </a:ext>
            </a:extLst>
          </p:cNvPr>
          <p:cNvSpPr txBox="1"/>
          <p:nvPr/>
        </p:nvSpPr>
        <p:spPr>
          <a:xfrm>
            <a:off x="508685" y="4953000"/>
            <a:ext cx="558981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 Analysis of the SAG21 gene to identify expressed gene models (A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redicted models for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TAIR: At4g02380.1, .2 and .3 where yellow indicates the open reading frame and blue the 5’ and 3’ UTR sequences, thin line indicates the intron; sizes of the predicted proteins are shown on the right of the figur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n reading frames  showing positions of primers used to test transcript presence for the different models, and predicted product sizes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 of PCR using primer combinations demonstrating the presence/absence of potential transcripts based on the different gene models: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NA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ic DNA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NA-U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 cDNA (unstressed)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NA-S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 cDNA (salt stressed),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NA-D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ling cDNA (drought stressed),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gative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rol;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ignment of At4g02380.1 predicted amino acid sequence with orthologous genes from other species.</a:t>
            </a:r>
          </a:p>
        </p:txBody>
      </p:sp>
    </p:spTree>
    <p:extLst>
      <p:ext uri="{BB962C8B-B14F-4D97-AF65-F5344CB8AC3E}">
        <p14:creationId xmlns:p14="http://schemas.microsoft.com/office/powerpoint/2010/main" val="1710696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3">
            <a:extLst>
              <a:ext uri="{FF2B5EF4-FFF2-40B4-BE49-F238E27FC236}">
                <a16:creationId xmlns:a16="http://schemas.microsoft.com/office/drawing/2014/main" id="{DD4B000A-81A9-EB83-BA47-134DF849F52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05" t="10330" r="23337" b="20361"/>
          <a:stretch/>
        </p:blipFill>
        <p:spPr bwMode="auto">
          <a:xfrm>
            <a:off x="2095527" y="1049854"/>
            <a:ext cx="2767718" cy="24372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6" name="Straight Connector 7">
            <a:extLst>
              <a:ext uri="{FF2B5EF4-FFF2-40B4-BE49-F238E27FC236}">
                <a16:creationId xmlns:a16="http://schemas.microsoft.com/office/drawing/2014/main" id="{24F46413-4DD1-E844-358D-078110B4AEE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4077297" y="7325097"/>
            <a:ext cx="664473" cy="0"/>
          </a:xfrm>
          <a:prstGeom prst="line">
            <a:avLst/>
          </a:prstGeom>
          <a:noFill/>
          <a:ln w="19050" algn="ctr">
            <a:solidFill>
              <a:srgbClr val="FFFF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6BD53018-FB26-5C9C-889D-FFE2FC6F59A9}"/>
              </a:ext>
            </a:extLst>
          </p:cNvPr>
          <p:cNvSpPr txBox="1"/>
          <p:nvPr/>
        </p:nvSpPr>
        <p:spPr>
          <a:xfrm>
            <a:off x="2961254" y="1050286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 2          3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EC581D1-4828-606A-63C8-DCF3805F174B}"/>
              </a:ext>
            </a:extLst>
          </p:cNvPr>
          <p:cNvSpPr txBox="1"/>
          <p:nvPr/>
        </p:nvSpPr>
        <p:spPr>
          <a:xfrm>
            <a:off x="2653623" y="1377958"/>
            <a:ext cx="307632" cy="1838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H</a:t>
            </a:r>
          </a:p>
        </p:txBody>
      </p:sp>
      <p:graphicFrame>
        <p:nvGraphicFramePr>
          <p:cNvPr id="51" name="Table 51">
            <a:extLst>
              <a:ext uri="{FF2B5EF4-FFF2-40B4-BE49-F238E27FC236}">
                <a16:creationId xmlns:a16="http://schemas.microsoft.com/office/drawing/2014/main" id="{CF83D72F-0DD0-30EA-BCA9-1F1F3A9424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8968039"/>
              </p:ext>
            </p:extLst>
          </p:nvPr>
        </p:nvGraphicFramePr>
        <p:xfrm>
          <a:off x="1857064" y="3614757"/>
          <a:ext cx="3244644" cy="2804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0774">
                  <a:extLst>
                    <a:ext uri="{9D8B030D-6E8A-4147-A177-3AD203B41FA5}">
                      <a16:colId xmlns:a16="http://schemas.microsoft.com/office/drawing/2014/main" val="2539793458"/>
                    </a:ext>
                  </a:extLst>
                </a:gridCol>
                <a:gridCol w="939747">
                  <a:extLst>
                    <a:ext uri="{9D8B030D-6E8A-4147-A177-3AD203B41FA5}">
                      <a16:colId xmlns:a16="http://schemas.microsoft.com/office/drawing/2014/main" val="2649873909"/>
                    </a:ext>
                  </a:extLst>
                </a:gridCol>
                <a:gridCol w="892277">
                  <a:extLst>
                    <a:ext uri="{9D8B030D-6E8A-4147-A177-3AD203B41FA5}">
                      <a16:colId xmlns:a16="http://schemas.microsoft.com/office/drawing/2014/main" val="4001477359"/>
                    </a:ext>
                  </a:extLst>
                </a:gridCol>
                <a:gridCol w="871846">
                  <a:extLst>
                    <a:ext uri="{9D8B030D-6E8A-4147-A177-3AD203B41FA5}">
                      <a16:colId xmlns:a16="http://schemas.microsoft.com/office/drawing/2014/main" val="40380081"/>
                    </a:ext>
                  </a:extLst>
                </a:gridCol>
              </a:tblGrid>
              <a:tr h="211487">
                <a:tc>
                  <a:txBody>
                    <a:bodyPr/>
                    <a:lstStyle/>
                    <a:p>
                      <a:endParaRPr lang="en-GB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732613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WRKY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T4G309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8334061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GFP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776970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Empty vecto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52247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620175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1026639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99002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35727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2023251"/>
                  </a:ext>
                </a:extLst>
              </a:tr>
            </a:tbl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2987808F-BE65-A3FE-36B2-DAA2C94DB40B}"/>
              </a:ext>
            </a:extLst>
          </p:cNvPr>
          <p:cNvSpPr txBox="1"/>
          <p:nvPr/>
        </p:nvSpPr>
        <p:spPr>
          <a:xfrm>
            <a:off x="892143" y="6596703"/>
            <a:ext cx="51620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A WRKY TF Y1H results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-1-hybrid interactions between WRKY transcription factors and representative replicate of fragment 2 of th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(-178 to -479 upstream of the ATG). Above: interactions on SD-LTH plate; below: Table to show position of different WRKY TFs.</a:t>
            </a:r>
          </a:p>
        </p:txBody>
      </p:sp>
    </p:spTree>
    <p:extLst>
      <p:ext uri="{BB962C8B-B14F-4D97-AF65-F5344CB8AC3E}">
        <p14:creationId xmlns:p14="http://schemas.microsoft.com/office/powerpoint/2010/main" val="8428747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petri dish&#10;&#10;Description automatically generated">
            <a:extLst>
              <a:ext uri="{FF2B5EF4-FFF2-40B4-BE49-F238E27FC236}">
                <a16:creationId xmlns:a16="http://schemas.microsoft.com/office/drawing/2014/main" id="{999716C1-25ED-3136-4CE1-A826DE7F50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42" t="46393" r="22388" b="20735"/>
          <a:stretch/>
        </p:blipFill>
        <p:spPr>
          <a:xfrm>
            <a:off x="2084880" y="1424158"/>
            <a:ext cx="2671442" cy="2625183"/>
          </a:xfrm>
          <a:prstGeom prst="rect">
            <a:avLst/>
          </a:prstGeom>
        </p:spPr>
      </p:pic>
      <p:graphicFrame>
        <p:nvGraphicFramePr>
          <p:cNvPr id="4" name="Table 51">
            <a:extLst>
              <a:ext uri="{FF2B5EF4-FFF2-40B4-BE49-F238E27FC236}">
                <a16:creationId xmlns:a16="http://schemas.microsoft.com/office/drawing/2014/main" id="{B6956FC1-F0D9-DE94-A240-84AD4D0992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6939293"/>
              </p:ext>
            </p:extLst>
          </p:nvPr>
        </p:nvGraphicFramePr>
        <p:xfrm>
          <a:off x="1493604" y="4953000"/>
          <a:ext cx="3870791" cy="26746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45132">
                  <a:extLst>
                    <a:ext uri="{9D8B030D-6E8A-4147-A177-3AD203B41FA5}">
                      <a16:colId xmlns:a16="http://schemas.microsoft.com/office/drawing/2014/main" val="2539793458"/>
                    </a:ext>
                  </a:extLst>
                </a:gridCol>
                <a:gridCol w="1121098">
                  <a:extLst>
                    <a:ext uri="{9D8B030D-6E8A-4147-A177-3AD203B41FA5}">
                      <a16:colId xmlns:a16="http://schemas.microsoft.com/office/drawing/2014/main" val="2649873909"/>
                    </a:ext>
                  </a:extLst>
                </a:gridCol>
                <a:gridCol w="1064467">
                  <a:extLst>
                    <a:ext uri="{9D8B030D-6E8A-4147-A177-3AD203B41FA5}">
                      <a16:colId xmlns:a16="http://schemas.microsoft.com/office/drawing/2014/main" val="4001477359"/>
                    </a:ext>
                  </a:extLst>
                </a:gridCol>
                <a:gridCol w="1040094">
                  <a:extLst>
                    <a:ext uri="{9D8B030D-6E8A-4147-A177-3AD203B41FA5}">
                      <a16:colId xmlns:a16="http://schemas.microsoft.com/office/drawing/2014/main" val="40380081"/>
                    </a:ext>
                  </a:extLst>
                </a:gridCol>
              </a:tblGrid>
              <a:tr h="211487">
                <a:tc>
                  <a:txBody>
                    <a:bodyPr/>
                    <a:lstStyle/>
                    <a:p>
                      <a:endParaRPr lang="en-GB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732613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8334061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38/0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38/0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38/03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776970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52247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7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620175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1026639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NAC0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NAC05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99002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35727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-</a:t>
                      </a:r>
                      <a:r>
                        <a:rPr lang="en-GB" sz="1100" dirty="0" err="1"/>
                        <a:t>ve</a:t>
                      </a: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202325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6A70082-F1C4-8C77-3132-23182CB2669D}"/>
              </a:ext>
            </a:extLst>
          </p:cNvPr>
          <p:cNvSpPr txBox="1"/>
          <p:nvPr/>
        </p:nvSpPr>
        <p:spPr>
          <a:xfrm>
            <a:off x="2701946" y="1496441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 2          3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A38920-98AF-B04D-B5A7-BB7E96C4A661}"/>
              </a:ext>
            </a:extLst>
          </p:cNvPr>
          <p:cNvSpPr txBox="1"/>
          <p:nvPr/>
        </p:nvSpPr>
        <p:spPr>
          <a:xfrm>
            <a:off x="2394315" y="1824113"/>
            <a:ext cx="307632" cy="1838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2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47810CC-8158-87CF-5A67-4C2FB03EBA3E}"/>
              </a:ext>
            </a:extLst>
          </p:cNvPr>
          <p:cNvSpPr txBox="1"/>
          <p:nvPr/>
        </p:nvSpPr>
        <p:spPr>
          <a:xfrm>
            <a:off x="987678" y="7994060"/>
            <a:ext cx="516207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B NAC TF Y1H results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-1-hybrid interactions between NAC transcription factors and representative replicate of fragment 1 of th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(-1 to -333 upstream of the ATG). Above: interactions on SD-LTH plate; below: Table to show position of three replicates of the different NAC TFs. (independent experiment to that shown in Figure 1). </a:t>
            </a:r>
          </a:p>
        </p:txBody>
      </p:sp>
    </p:spTree>
    <p:extLst>
      <p:ext uri="{BB962C8B-B14F-4D97-AF65-F5344CB8AC3E}">
        <p14:creationId xmlns:p14="http://schemas.microsoft.com/office/powerpoint/2010/main" val="2246052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5433915F-4C03-9FAF-BF11-942B3FE2931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37" t="7448" r="23305" b="19231"/>
          <a:stretch/>
        </p:blipFill>
        <p:spPr bwMode="auto">
          <a:xfrm>
            <a:off x="644599" y="1440216"/>
            <a:ext cx="1791997" cy="164121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3FB244F-1416-F52A-25A8-0FD19808816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51" t="-28" r="14395" b="18955"/>
          <a:stretch/>
        </p:blipFill>
        <p:spPr bwMode="auto">
          <a:xfrm>
            <a:off x="2594452" y="1440215"/>
            <a:ext cx="1893877" cy="164121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EEA7B82-FAF2-D0F7-1C32-3786596EC75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21" t="26426" r="29674" b="18737"/>
          <a:stretch/>
        </p:blipFill>
        <p:spPr bwMode="auto">
          <a:xfrm>
            <a:off x="4646185" y="1431401"/>
            <a:ext cx="1779455" cy="16412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A56B24AB-EE22-9A8D-3780-3938844B0042}"/>
              </a:ext>
            </a:extLst>
          </p:cNvPr>
          <p:cNvSpPr txBox="1"/>
          <p:nvPr/>
        </p:nvSpPr>
        <p:spPr>
          <a:xfrm>
            <a:off x="1190357" y="1466699"/>
            <a:ext cx="12462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solidFill>
                  <a:srgbClr val="FF0000"/>
                </a:solidFill>
              </a:rPr>
              <a:t>1          2          3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4C0B18A-AB3D-F5AA-4156-E6C5E5700F4C}"/>
              </a:ext>
            </a:extLst>
          </p:cNvPr>
          <p:cNvSpPr txBox="1"/>
          <p:nvPr/>
        </p:nvSpPr>
        <p:spPr>
          <a:xfrm>
            <a:off x="957613" y="1614927"/>
            <a:ext cx="3076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solidFill>
                  <a:srgbClr val="FF0000"/>
                </a:solidFill>
              </a:rPr>
              <a:t>A</a:t>
            </a:r>
          </a:p>
          <a:p>
            <a:r>
              <a:rPr lang="en-GB" sz="900" dirty="0">
                <a:solidFill>
                  <a:srgbClr val="FF0000"/>
                </a:solidFill>
              </a:rPr>
              <a:t>B</a:t>
            </a:r>
          </a:p>
          <a:p>
            <a:r>
              <a:rPr lang="en-GB" sz="900" dirty="0">
                <a:solidFill>
                  <a:srgbClr val="FF0000"/>
                </a:solidFill>
              </a:rPr>
              <a:t>C</a:t>
            </a:r>
          </a:p>
          <a:p>
            <a:r>
              <a:rPr lang="en-GB" sz="900" dirty="0">
                <a:solidFill>
                  <a:srgbClr val="FF0000"/>
                </a:solidFill>
              </a:rPr>
              <a:t>D</a:t>
            </a:r>
          </a:p>
          <a:p>
            <a:r>
              <a:rPr lang="en-GB" sz="900" dirty="0">
                <a:solidFill>
                  <a:srgbClr val="FF0000"/>
                </a:solidFill>
              </a:rPr>
              <a:t>E</a:t>
            </a:r>
          </a:p>
          <a:p>
            <a:r>
              <a:rPr lang="en-GB" sz="900" dirty="0">
                <a:solidFill>
                  <a:srgbClr val="FF0000"/>
                </a:solidFill>
              </a:rPr>
              <a:t>F</a:t>
            </a:r>
          </a:p>
          <a:p>
            <a:r>
              <a:rPr lang="en-GB" sz="900" dirty="0">
                <a:solidFill>
                  <a:srgbClr val="FF0000"/>
                </a:solidFill>
              </a:rPr>
              <a:t>G</a:t>
            </a:r>
          </a:p>
          <a:p>
            <a:r>
              <a:rPr lang="en-GB" sz="9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99C718F-5411-B162-ED63-63E2DE686828}"/>
              </a:ext>
            </a:extLst>
          </p:cNvPr>
          <p:cNvSpPr txBox="1"/>
          <p:nvPr/>
        </p:nvSpPr>
        <p:spPr>
          <a:xfrm>
            <a:off x="3069956" y="1455940"/>
            <a:ext cx="12462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solidFill>
                  <a:srgbClr val="FF0000"/>
                </a:solidFill>
              </a:rPr>
              <a:t>1          2          3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9DA0F7A-B84A-53A1-81B6-3AAEA075F6F5}"/>
              </a:ext>
            </a:extLst>
          </p:cNvPr>
          <p:cNvSpPr txBox="1"/>
          <p:nvPr/>
        </p:nvSpPr>
        <p:spPr>
          <a:xfrm>
            <a:off x="2896977" y="1598681"/>
            <a:ext cx="3076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solidFill>
                  <a:srgbClr val="FF0000"/>
                </a:solidFill>
              </a:rPr>
              <a:t>A</a:t>
            </a:r>
          </a:p>
          <a:p>
            <a:r>
              <a:rPr lang="en-GB" sz="900" dirty="0">
                <a:solidFill>
                  <a:srgbClr val="FF0000"/>
                </a:solidFill>
              </a:rPr>
              <a:t>B</a:t>
            </a:r>
          </a:p>
          <a:p>
            <a:r>
              <a:rPr lang="en-GB" sz="900" dirty="0">
                <a:solidFill>
                  <a:srgbClr val="FF0000"/>
                </a:solidFill>
              </a:rPr>
              <a:t>C</a:t>
            </a:r>
          </a:p>
          <a:p>
            <a:r>
              <a:rPr lang="en-GB" sz="900" dirty="0">
                <a:solidFill>
                  <a:srgbClr val="FF0000"/>
                </a:solidFill>
              </a:rPr>
              <a:t>D</a:t>
            </a:r>
          </a:p>
          <a:p>
            <a:r>
              <a:rPr lang="en-GB" sz="900" dirty="0">
                <a:solidFill>
                  <a:srgbClr val="FF0000"/>
                </a:solidFill>
              </a:rPr>
              <a:t>E</a:t>
            </a:r>
          </a:p>
          <a:p>
            <a:r>
              <a:rPr lang="en-GB" sz="900" dirty="0">
                <a:solidFill>
                  <a:srgbClr val="FF0000"/>
                </a:solidFill>
              </a:rPr>
              <a:t>F</a:t>
            </a:r>
          </a:p>
          <a:p>
            <a:r>
              <a:rPr lang="en-GB" sz="900" dirty="0">
                <a:solidFill>
                  <a:srgbClr val="FF0000"/>
                </a:solidFill>
              </a:rPr>
              <a:t>G</a:t>
            </a:r>
          </a:p>
          <a:p>
            <a:r>
              <a:rPr lang="en-GB" sz="9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4132F66-D72A-5114-B9B6-2AC672F959CB}"/>
              </a:ext>
            </a:extLst>
          </p:cNvPr>
          <p:cNvSpPr txBox="1"/>
          <p:nvPr/>
        </p:nvSpPr>
        <p:spPr>
          <a:xfrm>
            <a:off x="5106993" y="1477882"/>
            <a:ext cx="12462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solidFill>
                  <a:srgbClr val="FF0000"/>
                </a:solidFill>
              </a:rPr>
              <a:t>1          2          3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A897032-4060-8B00-3B58-7033B3D78E0A}"/>
              </a:ext>
            </a:extLst>
          </p:cNvPr>
          <p:cNvSpPr txBox="1"/>
          <p:nvPr/>
        </p:nvSpPr>
        <p:spPr>
          <a:xfrm>
            <a:off x="4981205" y="1597476"/>
            <a:ext cx="3076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solidFill>
                  <a:srgbClr val="FF0000"/>
                </a:solidFill>
              </a:rPr>
              <a:t>A</a:t>
            </a:r>
          </a:p>
          <a:p>
            <a:r>
              <a:rPr lang="en-GB" sz="900" dirty="0">
                <a:solidFill>
                  <a:srgbClr val="FF0000"/>
                </a:solidFill>
              </a:rPr>
              <a:t>B</a:t>
            </a:r>
          </a:p>
          <a:p>
            <a:r>
              <a:rPr lang="en-GB" sz="900" dirty="0">
                <a:solidFill>
                  <a:srgbClr val="FF0000"/>
                </a:solidFill>
              </a:rPr>
              <a:t>C</a:t>
            </a:r>
          </a:p>
          <a:p>
            <a:r>
              <a:rPr lang="en-GB" sz="900" dirty="0">
                <a:solidFill>
                  <a:srgbClr val="FF0000"/>
                </a:solidFill>
              </a:rPr>
              <a:t>D</a:t>
            </a:r>
          </a:p>
          <a:p>
            <a:r>
              <a:rPr lang="en-GB" sz="900" dirty="0">
                <a:solidFill>
                  <a:srgbClr val="FF0000"/>
                </a:solidFill>
              </a:rPr>
              <a:t>E</a:t>
            </a:r>
          </a:p>
          <a:p>
            <a:r>
              <a:rPr lang="en-GB" sz="900" dirty="0">
                <a:solidFill>
                  <a:srgbClr val="FF0000"/>
                </a:solidFill>
              </a:rPr>
              <a:t>F</a:t>
            </a:r>
          </a:p>
          <a:p>
            <a:r>
              <a:rPr lang="en-GB" sz="900" dirty="0">
                <a:solidFill>
                  <a:srgbClr val="FF0000"/>
                </a:solidFill>
              </a:rPr>
              <a:t>G</a:t>
            </a:r>
          </a:p>
          <a:p>
            <a:r>
              <a:rPr lang="en-GB" sz="900" dirty="0">
                <a:solidFill>
                  <a:srgbClr val="FF0000"/>
                </a:solidFill>
              </a:rPr>
              <a:t>H</a:t>
            </a:r>
          </a:p>
        </p:txBody>
      </p:sp>
      <p:graphicFrame>
        <p:nvGraphicFramePr>
          <p:cNvPr id="49" name="Table 51">
            <a:extLst>
              <a:ext uri="{FF2B5EF4-FFF2-40B4-BE49-F238E27FC236}">
                <a16:creationId xmlns:a16="http://schemas.microsoft.com/office/drawing/2014/main" id="{1E639CCD-1DC0-0F4C-F6EF-5D41F5C340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662514"/>
              </p:ext>
            </p:extLst>
          </p:nvPr>
        </p:nvGraphicFramePr>
        <p:xfrm>
          <a:off x="1736561" y="3775177"/>
          <a:ext cx="3244644" cy="2804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0774">
                  <a:extLst>
                    <a:ext uri="{9D8B030D-6E8A-4147-A177-3AD203B41FA5}">
                      <a16:colId xmlns:a16="http://schemas.microsoft.com/office/drawing/2014/main" val="2539793458"/>
                    </a:ext>
                  </a:extLst>
                </a:gridCol>
                <a:gridCol w="939747">
                  <a:extLst>
                    <a:ext uri="{9D8B030D-6E8A-4147-A177-3AD203B41FA5}">
                      <a16:colId xmlns:a16="http://schemas.microsoft.com/office/drawing/2014/main" val="2649873909"/>
                    </a:ext>
                  </a:extLst>
                </a:gridCol>
                <a:gridCol w="892277">
                  <a:extLst>
                    <a:ext uri="{9D8B030D-6E8A-4147-A177-3AD203B41FA5}">
                      <a16:colId xmlns:a16="http://schemas.microsoft.com/office/drawing/2014/main" val="4001477359"/>
                    </a:ext>
                  </a:extLst>
                </a:gridCol>
                <a:gridCol w="871846">
                  <a:extLst>
                    <a:ext uri="{9D8B030D-6E8A-4147-A177-3AD203B41FA5}">
                      <a16:colId xmlns:a16="http://schemas.microsoft.com/office/drawing/2014/main" val="40380081"/>
                    </a:ext>
                  </a:extLst>
                </a:gridCol>
              </a:tblGrid>
              <a:tr h="211487">
                <a:tc>
                  <a:txBody>
                    <a:bodyPr/>
                    <a:lstStyle/>
                    <a:p>
                      <a:endParaRPr lang="en-GB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732613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WRKY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AT4G309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8334061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GFP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776970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Empty vecto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52247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620175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1026639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9900258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357275"/>
                  </a:ext>
                </a:extLst>
              </a:tr>
              <a:tr h="211487">
                <a:tc>
                  <a:txBody>
                    <a:bodyPr/>
                    <a:lstStyle/>
                    <a:p>
                      <a:r>
                        <a:rPr lang="en-GB" dirty="0">
                          <a:solidFill>
                            <a:srgbClr val="FF0000"/>
                          </a:solidFill>
                        </a:rPr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WRKY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2023251"/>
                  </a:ext>
                </a:extLst>
              </a:tr>
            </a:tbl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id="{783680B5-CA19-340E-38DF-29C264F324B3}"/>
              </a:ext>
            </a:extLst>
          </p:cNvPr>
          <p:cNvSpPr txBox="1"/>
          <p:nvPr/>
        </p:nvSpPr>
        <p:spPr>
          <a:xfrm>
            <a:off x="910872" y="1148980"/>
            <a:ext cx="1629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Mutated W-box 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EC8701F-16FD-5980-C33B-C15C653E89AB}"/>
              </a:ext>
            </a:extLst>
          </p:cNvPr>
          <p:cNvSpPr txBox="1"/>
          <p:nvPr/>
        </p:nvSpPr>
        <p:spPr>
          <a:xfrm>
            <a:off x="4788110" y="1148980"/>
            <a:ext cx="18840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Mutated W-box 4  and 5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A7C03BA-1E0C-FBE7-DF1A-A75B433F35E8}"/>
              </a:ext>
            </a:extLst>
          </p:cNvPr>
          <p:cNvSpPr txBox="1"/>
          <p:nvPr/>
        </p:nvSpPr>
        <p:spPr>
          <a:xfrm>
            <a:off x="2870976" y="1148980"/>
            <a:ext cx="1476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Mutated W-box 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6A58223-96FE-72FE-EC70-B069599A2C47}"/>
              </a:ext>
            </a:extLst>
          </p:cNvPr>
          <p:cNvSpPr txBox="1"/>
          <p:nvPr/>
        </p:nvSpPr>
        <p:spPr>
          <a:xfrm>
            <a:off x="910872" y="7472042"/>
            <a:ext cx="516207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C WRKY TF Y1H results from mutated W-box 4 and 5 in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-1-hybrid interactions between WRKY transcription factors and representative replicate of fragment 2 of th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(-178 to -479 upstream of the ATG). Above: interactions on SD-LTH plate for promoter fragments including mutations of W-boxes 4 and 5; below: Table to show position of three replicates of the different WRKY TFs. </a:t>
            </a:r>
          </a:p>
        </p:txBody>
      </p:sp>
    </p:spTree>
    <p:extLst>
      <p:ext uri="{BB962C8B-B14F-4D97-AF65-F5344CB8AC3E}">
        <p14:creationId xmlns:p14="http://schemas.microsoft.com/office/powerpoint/2010/main" val="2878973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">
            <a:extLst>
              <a:ext uri="{FF2B5EF4-FFF2-40B4-BE49-F238E27FC236}">
                <a16:creationId xmlns:a16="http://schemas.microsoft.com/office/drawing/2014/main" id="{DCA27308-8DCB-1C70-985B-5B32103476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943" t="-7594" r="-7730" b="-5905"/>
          <a:stretch/>
        </p:blipFill>
        <p:spPr bwMode="auto">
          <a:xfrm rot="10800000" flipH="1" flipV="1">
            <a:off x="545431" y="1443789"/>
            <a:ext cx="4973052" cy="5005136"/>
          </a:xfrm>
          <a:prstGeom prst="rect">
            <a:avLst/>
          </a:prstGeom>
          <a:noFill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AD4B1EE-6B32-1980-641D-9011DCF2B60E}"/>
              </a:ext>
            </a:extLst>
          </p:cNvPr>
          <p:cNvSpPr txBox="1"/>
          <p:nvPr/>
        </p:nvSpPr>
        <p:spPr>
          <a:xfrm>
            <a:off x="1041501" y="6923402"/>
            <a:ext cx="516207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D NAC TF Y1H results from mutated cis element in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 1-hybrid screens of NAC TFs against either a WT or mutagenize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fragment 1 (-1 to -333bp upstream of the ATG)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of the WT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, with the putative NAC binding motif highlighted (TGCCG)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of the mutagenize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where the putative NAC binding motif was mutagenized to TTTTT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C TFs screened against WT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on leucine tryptophan dropout (-LT DO) media and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ucine tryptophan histidine dropout (-LTH media)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C TFs screened against mutagenize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on -LT DO media and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LTH DO media. Each panel represents three replicates and is from a single Petri dish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D7DB49A-F1C2-D616-3BF4-0EC5287C18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858" t="23306" r="25457" b="22033"/>
          <a:stretch/>
        </p:blipFill>
        <p:spPr>
          <a:xfrm>
            <a:off x="2075635" y="2854963"/>
            <a:ext cx="1541255" cy="1503184"/>
          </a:xfrm>
          <a:prstGeom prst="rect">
            <a:avLst/>
          </a:prstGeom>
        </p:spPr>
      </p:pic>
      <p:pic>
        <p:nvPicPr>
          <p:cNvPr id="5" name="Picture 4" descr="Image preview">
            <a:extLst>
              <a:ext uri="{FF2B5EF4-FFF2-40B4-BE49-F238E27FC236}">
                <a16:creationId xmlns:a16="http://schemas.microsoft.com/office/drawing/2014/main" id="{282D7318-5BE4-3C19-11BC-A421803DC04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1" t="16416" r="28575" b="26760"/>
          <a:stretch/>
        </p:blipFill>
        <p:spPr bwMode="auto">
          <a:xfrm>
            <a:off x="2074931" y="4684085"/>
            <a:ext cx="1586314" cy="1659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54EB829-C59B-EF71-5840-2BBAAAD78E4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5522" t="24677" r="25050" b="26138"/>
          <a:stretch/>
        </p:blipFill>
        <p:spPr>
          <a:xfrm>
            <a:off x="3649832" y="2854964"/>
            <a:ext cx="1659147" cy="15031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A142F06-80CD-C023-DCD3-79B0CFBA03F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0347" t="23937" r="28061" b="23207"/>
          <a:stretch/>
        </p:blipFill>
        <p:spPr>
          <a:xfrm>
            <a:off x="3692190" y="4684085"/>
            <a:ext cx="1637928" cy="1659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3967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356ABC7-3AAC-70D9-7CBC-0FC739343A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2126846"/>
              </p:ext>
            </p:extLst>
          </p:nvPr>
        </p:nvGraphicFramePr>
        <p:xfrm>
          <a:off x="1454018" y="5501079"/>
          <a:ext cx="3845560" cy="178193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49275">
                  <a:extLst>
                    <a:ext uri="{9D8B030D-6E8A-4147-A177-3AD203B41FA5}">
                      <a16:colId xmlns:a16="http://schemas.microsoft.com/office/drawing/2014/main" val="2587301199"/>
                    </a:ext>
                  </a:extLst>
                </a:gridCol>
                <a:gridCol w="1049655">
                  <a:extLst>
                    <a:ext uri="{9D8B030D-6E8A-4147-A177-3AD203B41FA5}">
                      <a16:colId xmlns:a16="http://schemas.microsoft.com/office/drawing/2014/main" val="2436218713"/>
                    </a:ext>
                  </a:extLst>
                </a:gridCol>
                <a:gridCol w="1076325">
                  <a:extLst>
                    <a:ext uri="{9D8B030D-6E8A-4147-A177-3AD203B41FA5}">
                      <a16:colId xmlns:a16="http://schemas.microsoft.com/office/drawing/2014/main" val="1095301263"/>
                    </a:ext>
                  </a:extLst>
                </a:gridCol>
                <a:gridCol w="1170305">
                  <a:extLst>
                    <a:ext uri="{9D8B030D-6E8A-4147-A177-3AD203B41FA5}">
                      <a16:colId xmlns:a16="http://schemas.microsoft.com/office/drawing/2014/main" val="1143507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628406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RF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dirty="0">
                          <a:effectLst/>
                        </a:rPr>
                        <a:t>TCP8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GBF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478823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B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RF0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HB0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ZAT1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73555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dirty="0">
                          <a:effectLst/>
                        </a:rPr>
                        <a:t>ERF0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HB1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HMG-Box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55194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RF10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HB5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-v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593958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RF1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NAC3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-v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115785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ERF1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NAC10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-v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400635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TCP4 V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AHL1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902995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H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TCP4 V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>
                          <a:effectLst/>
                        </a:rPr>
                        <a:t>ABF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08479538"/>
                  </a:ext>
                </a:extLst>
              </a:tr>
            </a:tbl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66CFD96B-4306-492C-7D6D-A8C204D870C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09" t="6315" r="26230" b="27655"/>
          <a:stretch/>
        </p:blipFill>
        <p:spPr bwMode="auto">
          <a:xfrm>
            <a:off x="1050118" y="738145"/>
            <a:ext cx="2176976" cy="218574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C4BB900-8994-9A10-8127-5962336A00A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71" t="9507" r="26821" b="29925"/>
          <a:stretch/>
        </p:blipFill>
        <p:spPr bwMode="auto">
          <a:xfrm>
            <a:off x="3459224" y="774588"/>
            <a:ext cx="2214527" cy="214930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8A1EA7F5-6B39-16A2-8F04-4C40F4BF2F65}"/>
              </a:ext>
            </a:extLst>
          </p:cNvPr>
          <p:cNvGrpSpPr/>
          <p:nvPr/>
        </p:nvGrpSpPr>
        <p:grpSpPr>
          <a:xfrm>
            <a:off x="1534406" y="3296693"/>
            <a:ext cx="1120686" cy="1694922"/>
            <a:chOff x="0" y="0"/>
            <a:chExt cx="2171700" cy="3486150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1B630253-417C-A8A0-A3B2-917961CAA7AB}"/>
                </a:ext>
              </a:extLst>
            </p:cNvPr>
            <p:cNvCxnSpPr/>
            <p:nvPr/>
          </p:nvCxnSpPr>
          <p:spPr>
            <a:xfrm>
              <a:off x="685800" y="0"/>
              <a:ext cx="0" cy="348615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E83F56BB-53A4-28CE-A276-F14D0A34981F}"/>
                </a:ext>
              </a:extLst>
            </p:cNvPr>
            <p:cNvCxnSpPr/>
            <p:nvPr/>
          </p:nvCxnSpPr>
          <p:spPr>
            <a:xfrm>
              <a:off x="1485900" y="0"/>
              <a:ext cx="0" cy="348615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C060453C-1D16-6212-C7A0-E5F8407AF72F}"/>
                </a:ext>
              </a:extLst>
            </p:cNvPr>
            <p:cNvCxnSpPr/>
            <p:nvPr/>
          </p:nvCxnSpPr>
          <p:spPr>
            <a:xfrm flipH="1">
              <a:off x="0" y="34290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26AE7A56-C4D2-8794-8DD0-15AC5125108C}"/>
                </a:ext>
              </a:extLst>
            </p:cNvPr>
            <p:cNvCxnSpPr/>
            <p:nvPr/>
          </p:nvCxnSpPr>
          <p:spPr>
            <a:xfrm flipH="1">
              <a:off x="0" y="2563296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7EF2189D-6618-1EBE-FF7F-45E0F0A3E627}"/>
                </a:ext>
              </a:extLst>
            </p:cNvPr>
            <p:cNvCxnSpPr/>
            <p:nvPr/>
          </p:nvCxnSpPr>
          <p:spPr>
            <a:xfrm flipH="1">
              <a:off x="0" y="80010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35E6CFCA-161C-0584-D10C-3851E47C232A}"/>
                </a:ext>
              </a:extLst>
            </p:cNvPr>
            <p:cNvCxnSpPr/>
            <p:nvPr/>
          </p:nvCxnSpPr>
          <p:spPr>
            <a:xfrm flipH="1">
              <a:off x="0" y="125730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41696810-6650-6E46-1AF8-FE26F4E77239}"/>
                </a:ext>
              </a:extLst>
            </p:cNvPr>
            <p:cNvCxnSpPr/>
            <p:nvPr/>
          </p:nvCxnSpPr>
          <p:spPr>
            <a:xfrm flipH="1">
              <a:off x="0" y="171450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2016E608-6724-5E02-5AEE-5F9B7727D86F}"/>
                </a:ext>
              </a:extLst>
            </p:cNvPr>
            <p:cNvCxnSpPr/>
            <p:nvPr/>
          </p:nvCxnSpPr>
          <p:spPr>
            <a:xfrm flipH="1">
              <a:off x="0" y="217170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F71669DF-57C6-6A18-279D-49FC32576FA7}"/>
                </a:ext>
              </a:extLst>
            </p:cNvPr>
            <p:cNvCxnSpPr/>
            <p:nvPr/>
          </p:nvCxnSpPr>
          <p:spPr>
            <a:xfrm flipH="1">
              <a:off x="0" y="2976760"/>
              <a:ext cx="2171700" cy="0"/>
            </a:xfrm>
            <a:prstGeom prst="line">
              <a:avLst/>
            </a:prstGeom>
            <a:noFill/>
            <a:ln w="31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</p:grpSp>
      <p:pic>
        <p:nvPicPr>
          <p:cNvPr id="43" name="Picture 42">
            <a:extLst>
              <a:ext uri="{FF2B5EF4-FFF2-40B4-BE49-F238E27FC236}">
                <a16:creationId xmlns:a16="http://schemas.microsoft.com/office/drawing/2014/main" id="{DB4D07FA-071C-7E6F-DC6A-E5798D3274C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24" t="7545" r="26279" b="32867"/>
          <a:stretch/>
        </p:blipFill>
        <p:spPr bwMode="auto">
          <a:xfrm>
            <a:off x="3491251" y="3101329"/>
            <a:ext cx="2176975" cy="21809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42D15304-C794-352C-39F7-8742D6853CE7}"/>
              </a:ext>
            </a:extLst>
          </p:cNvPr>
          <p:cNvSpPr txBox="1"/>
          <p:nvPr/>
        </p:nvSpPr>
        <p:spPr>
          <a:xfrm>
            <a:off x="1062785" y="671792"/>
            <a:ext cx="582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A-F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8E375D2-C56E-0A49-0E1F-CAA645CEF870}"/>
              </a:ext>
            </a:extLst>
          </p:cNvPr>
          <p:cNvSpPr txBox="1"/>
          <p:nvPr/>
        </p:nvSpPr>
        <p:spPr>
          <a:xfrm>
            <a:off x="3501020" y="738145"/>
            <a:ext cx="552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B-F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7B094CB-E69A-64E4-47D9-A9B9FAE93B93}"/>
              </a:ext>
            </a:extLst>
          </p:cNvPr>
          <p:cNvSpPr txBox="1"/>
          <p:nvPr/>
        </p:nvSpPr>
        <p:spPr>
          <a:xfrm>
            <a:off x="3465072" y="3063523"/>
            <a:ext cx="588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D-F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88FCC51-8576-CD17-C54B-A753EEF142D1}"/>
              </a:ext>
            </a:extLst>
          </p:cNvPr>
          <p:cNvSpPr txBox="1"/>
          <p:nvPr/>
        </p:nvSpPr>
        <p:spPr>
          <a:xfrm>
            <a:off x="847965" y="7593924"/>
            <a:ext cx="516207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E Y1H results for TFs binding to fragments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-1-hybrid interactions between transcription factors and representative replicates of  (A) fragment 3 (-411 to -734) (B) fragment 4 (-645 to -962) , (C) fragment 5 (-893 to -1221), (D) fragment 6 (-1126 to -1436) of th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romoter. Above: interactions on SD-LTH plate for promoter fragments; below: Table shows position of the different TFs.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8CEEE12C-0E2C-7C60-7FBD-0A867449945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54" t="8373" r="28359" b="35562"/>
          <a:stretch/>
        </p:blipFill>
        <p:spPr bwMode="auto">
          <a:xfrm>
            <a:off x="1061412" y="3082541"/>
            <a:ext cx="2265716" cy="219970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A67C92C2-4BD9-B87C-773A-628B6B596DB3}"/>
              </a:ext>
            </a:extLst>
          </p:cNvPr>
          <p:cNvSpPr txBox="1"/>
          <p:nvPr/>
        </p:nvSpPr>
        <p:spPr>
          <a:xfrm>
            <a:off x="1039307" y="3034498"/>
            <a:ext cx="58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C-F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D15629-E66E-C970-FD57-C86F3AAB8ADB}"/>
              </a:ext>
            </a:extLst>
          </p:cNvPr>
          <p:cNvSpPr txBox="1"/>
          <p:nvPr/>
        </p:nvSpPr>
        <p:spPr>
          <a:xfrm>
            <a:off x="1645247" y="715141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2        3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3B467B3-C83F-6F0C-FB14-F01BFC7C2D5E}"/>
              </a:ext>
            </a:extLst>
          </p:cNvPr>
          <p:cNvSpPr txBox="1"/>
          <p:nvPr/>
        </p:nvSpPr>
        <p:spPr>
          <a:xfrm>
            <a:off x="1343061" y="870549"/>
            <a:ext cx="307632" cy="1715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61821C0-AB29-98D6-7A61-1C2002956392}"/>
              </a:ext>
            </a:extLst>
          </p:cNvPr>
          <p:cNvSpPr txBox="1"/>
          <p:nvPr/>
        </p:nvSpPr>
        <p:spPr>
          <a:xfrm>
            <a:off x="4053667" y="830294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2        3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A515BFF-0DE2-9D97-0CAF-4AC182822D3F}"/>
              </a:ext>
            </a:extLst>
          </p:cNvPr>
          <p:cNvSpPr txBox="1"/>
          <p:nvPr/>
        </p:nvSpPr>
        <p:spPr>
          <a:xfrm>
            <a:off x="1604764" y="3145014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2        3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5D2242B-7C19-6757-1714-50C34D2F41D5}"/>
              </a:ext>
            </a:extLst>
          </p:cNvPr>
          <p:cNvSpPr txBox="1"/>
          <p:nvPr/>
        </p:nvSpPr>
        <p:spPr>
          <a:xfrm>
            <a:off x="4053339" y="3125857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2        3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875A5B3-098C-592A-DE1B-7B7F20C4F133}"/>
              </a:ext>
            </a:extLst>
          </p:cNvPr>
          <p:cNvSpPr txBox="1"/>
          <p:nvPr/>
        </p:nvSpPr>
        <p:spPr>
          <a:xfrm>
            <a:off x="3780355" y="968793"/>
            <a:ext cx="307632" cy="1715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49766C-5B61-9225-1BD3-FE045DFCFA1F}"/>
              </a:ext>
            </a:extLst>
          </p:cNvPr>
          <p:cNvSpPr txBox="1"/>
          <p:nvPr/>
        </p:nvSpPr>
        <p:spPr>
          <a:xfrm>
            <a:off x="1413770" y="3307518"/>
            <a:ext cx="307632" cy="1715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AD1E25-3ECA-CEA9-F12A-E702D3A86CE3}"/>
              </a:ext>
            </a:extLst>
          </p:cNvPr>
          <p:cNvSpPr txBox="1"/>
          <p:nvPr/>
        </p:nvSpPr>
        <p:spPr>
          <a:xfrm>
            <a:off x="3870480" y="3272334"/>
            <a:ext cx="307632" cy="1715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F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G</a:t>
            </a:r>
          </a:p>
          <a:p>
            <a:pPr>
              <a:spcBef>
                <a:spcPts val="300"/>
              </a:spcBef>
            </a:pPr>
            <a:r>
              <a:rPr lang="en-GB" sz="1100" dirty="0">
                <a:solidFill>
                  <a:srgbClr val="FF0000"/>
                </a:solidFill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6042914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DD68B73-1E32-1267-D704-99AFEA421B4B}"/>
              </a:ext>
            </a:extLst>
          </p:cNvPr>
          <p:cNvSpPr txBox="1"/>
          <p:nvPr/>
        </p:nvSpPr>
        <p:spPr>
          <a:xfrm>
            <a:off x="888642" y="6301131"/>
            <a:ext cx="527593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E contd.  Y1H results for TFs binding to fragments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2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on SD-LTH plates; table shows position of representative replicate of the different TFs paired with (A) fragment 3 (F3; -411 to -7340; (B) fragments 5 (F5; -893 to -1221) and fragment 6 (F6; -1126 to -1436)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6091B8-DFF3-3216-00B8-A03007A3032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27" t="11008" r="24731" b="31230"/>
          <a:stretch/>
        </p:blipFill>
        <p:spPr bwMode="auto">
          <a:xfrm>
            <a:off x="748552" y="1089609"/>
            <a:ext cx="1848171" cy="188031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0885B7C-CB62-FC10-3F21-A87C4F406232}"/>
              </a:ext>
            </a:extLst>
          </p:cNvPr>
          <p:cNvSpPr txBox="1"/>
          <p:nvPr/>
        </p:nvSpPr>
        <p:spPr>
          <a:xfrm>
            <a:off x="769513" y="1028963"/>
            <a:ext cx="450945" cy="4459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EC933BF-43EA-41FD-39D0-5F946D0A0552}"/>
              </a:ext>
            </a:extLst>
          </p:cNvPr>
          <p:cNvGrpSpPr/>
          <p:nvPr/>
        </p:nvGrpSpPr>
        <p:grpSpPr>
          <a:xfrm>
            <a:off x="769513" y="3621046"/>
            <a:ext cx="1855649" cy="1940962"/>
            <a:chOff x="3413460" y="1028963"/>
            <a:chExt cx="1855649" cy="1940962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7837D7B-5D62-E6CF-4C33-EBB08272D1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42" t="6983" r="22276" b="21626"/>
            <a:stretch/>
          </p:blipFill>
          <p:spPr bwMode="auto">
            <a:xfrm>
              <a:off x="3429000" y="1089609"/>
              <a:ext cx="1840109" cy="188031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D67714E-74D3-E022-564C-773C38465B4E}"/>
                </a:ext>
              </a:extLst>
            </p:cNvPr>
            <p:cNvSpPr txBox="1"/>
            <p:nvPr/>
          </p:nvSpPr>
          <p:spPr>
            <a:xfrm>
              <a:off x="3413460" y="1028963"/>
              <a:ext cx="450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chemeClr val="bg1"/>
                  </a:solidFill>
                </a:rPr>
                <a:t>B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0086BCFC-6C53-6C01-660F-1FD712B4006C}"/>
              </a:ext>
            </a:extLst>
          </p:cNvPr>
          <p:cNvSpPr txBox="1"/>
          <p:nvPr/>
        </p:nvSpPr>
        <p:spPr>
          <a:xfrm>
            <a:off x="961762" y="1306492"/>
            <a:ext cx="30763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r>
              <a:rPr lang="en-GB" sz="1100" dirty="0">
                <a:solidFill>
                  <a:srgbClr val="FF0000"/>
                </a:solidFill>
              </a:rPr>
              <a:t>F</a:t>
            </a:r>
          </a:p>
          <a:p>
            <a:r>
              <a:rPr lang="en-GB" sz="1100" dirty="0">
                <a:solidFill>
                  <a:srgbClr val="FF0000"/>
                </a:solidFill>
              </a:rPr>
              <a:t>G</a:t>
            </a:r>
          </a:p>
          <a:p>
            <a:r>
              <a:rPr lang="en-GB" sz="1100" dirty="0">
                <a:solidFill>
                  <a:srgbClr val="FF0000"/>
                </a:solidFill>
              </a:rPr>
              <a:t>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3340064-3CF5-763B-F4D4-693273B25021}"/>
              </a:ext>
            </a:extLst>
          </p:cNvPr>
          <p:cNvSpPr txBox="1"/>
          <p:nvPr/>
        </p:nvSpPr>
        <p:spPr>
          <a:xfrm>
            <a:off x="1115578" y="1078043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  2         3 </a:t>
            </a:r>
          </a:p>
        </p:txBody>
      </p:sp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id="{0AA783D8-87BF-517A-79D6-EA30CB1FCA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5029845"/>
              </p:ext>
            </p:extLst>
          </p:nvPr>
        </p:nvGraphicFramePr>
        <p:xfrm>
          <a:off x="2867951" y="1124267"/>
          <a:ext cx="2923250" cy="162877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38523">
                  <a:extLst>
                    <a:ext uri="{9D8B030D-6E8A-4147-A177-3AD203B41FA5}">
                      <a16:colId xmlns:a16="http://schemas.microsoft.com/office/drawing/2014/main" val="1685530307"/>
                    </a:ext>
                  </a:extLst>
                </a:gridCol>
                <a:gridCol w="851176">
                  <a:extLst>
                    <a:ext uri="{9D8B030D-6E8A-4147-A177-3AD203B41FA5}">
                      <a16:colId xmlns:a16="http://schemas.microsoft.com/office/drawing/2014/main" val="3155553062"/>
                    </a:ext>
                  </a:extLst>
                </a:gridCol>
                <a:gridCol w="831850">
                  <a:extLst>
                    <a:ext uri="{9D8B030D-6E8A-4147-A177-3AD203B41FA5}">
                      <a16:colId xmlns:a16="http://schemas.microsoft.com/office/drawing/2014/main" val="4216873582"/>
                    </a:ext>
                  </a:extLst>
                </a:gridCol>
                <a:gridCol w="901701">
                  <a:extLst>
                    <a:ext uri="{9D8B030D-6E8A-4147-A177-3AD203B41FA5}">
                      <a16:colId xmlns:a16="http://schemas.microsoft.com/office/drawing/2014/main" val="281365884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1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2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5678827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A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c+HB12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b+HB12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a+HB12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905598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B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c+HB1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b+HB1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a+HB1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5098258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C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c+HB2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b+HB2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a+HB2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21446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D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c+ERF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b+ERF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a+ERF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9887272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E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c+ZAT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b+ZAT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3a+ZAT1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5600674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0500477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G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971549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H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-</a:t>
                      </a:r>
                      <a:r>
                        <a:rPr lang="en-GB" sz="1100" kern="100" dirty="0" err="1">
                          <a:effectLst/>
                        </a:rPr>
                        <a:t>ve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-</a:t>
                      </a:r>
                      <a:r>
                        <a:rPr lang="en-GB" sz="1100" kern="100" dirty="0" err="1">
                          <a:effectLst/>
                        </a:rPr>
                        <a:t>ve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116644746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38CBBFF2-8959-439A-E3AC-B064D58CB295}"/>
              </a:ext>
            </a:extLst>
          </p:cNvPr>
          <p:cNvSpPr txBox="1"/>
          <p:nvPr/>
        </p:nvSpPr>
        <p:spPr>
          <a:xfrm>
            <a:off x="1032572" y="3914984"/>
            <a:ext cx="30763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A</a:t>
            </a:r>
          </a:p>
          <a:p>
            <a:r>
              <a:rPr lang="en-GB" sz="1100" dirty="0">
                <a:solidFill>
                  <a:srgbClr val="FF0000"/>
                </a:solidFill>
              </a:rPr>
              <a:t>B</a:t>
            </a:r>
          </a:p>
          <a:p>
            <a:r>
              <a:rPr lang="en-GB" sz="1100" dirty="0">
                <a:solidFill>
                  <a:srgbClr val="FF0000"/>
                </a:solidFill>
              </a:rPr>
              <a:t>C</a:t>
            </a:r>
          </a:p>
          <a:p>
            <a:r>
              <a:rPr lang="en-GB" sz="1100" dirty="0">
                <a:solidFill>
                  <a:srgbClr val="FF0000"/>
                </a:solidFill>
              </a:rPr>
              <a:t>D</a:t>
            </a:r>
          </a:p>
          <a:p>
            <a:r>
              <a:rPr lang="en-GB" sz="1100" dirty="0">
                <a:solidFill>
                  <a:srgbClr val="FF0000"/>
                </a:solidFill>
              </a:rPr>
              <a:t>E</a:t>
            </a:r>
          </a:p>
          <a:p>
            <a:r>
              <a:rPr lang="en-GB" sz="1100" dirty="0">
                <a:solidFill>
                  <a:srgbClr val="FF0000"/>
                </a:solidFill>
              </a:rPr>
              <a:t>F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F0FB66D-350D-E43F-5E82-A1BABF932478}"/>
              </a:ext>
            </a:extLst>
          </p:cNvPr>
          <p:cNvSpPr txBox="1"/>
          <p:nvPr/>
        </p:nvSpPr>
        <p:spPr>
          <a:xfrm>
            <a:off x="1235998" y="3719864"/>
            <a:ext cx="1246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1       2       3 </a:t>
            </a:r>
          </a:p>
        </p:txBody>
      </p:sp>
      <p:graphicFrame>
        <p:nvGraphicFramePr>
          <p:cNvPr id="34" name="Table 33">
            <a:extLst>
              <a:ext uri="{FF2B5EF4-FFF2-40B4-BE49-F238E27FC236}">
                <a16:creationId xmlns:a16="http://schemas.microsoft.com/office/drawing/2014/main" id="{BCC57B0E-BCA4-53BC-B13F-A6A87E3310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3431447"/>
              </p:ext>
            </p:extLst>
          </p:nvPr>
        </p:nvGraphicFramePr>
        <p:xfrm>
          <a:off x="2867951" y="3805712"/>
          <a:ext cx="2554949" cy="12668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90564">
                  <a:extLst>
                    <a:ext uri="{9D8B030D-6E8A-4147-A177-3AD203B41FA5}">
                      <a16:colId xmlns:a16="http://schemas.microsoft.com/office/drawing/2014/main" val="2097590765"/>
                    </a:ext>
                  </a:extLst>
                </a:gridCol>
                <a:gridCol w="873735">
                  <a:extLst>
                    <a:ext uri="{9D8B030D-6E8A-4147-A177-3AD203B41FA5}">
                      <a16:colId xmlns:a16="http://schemas.microsoft.com/office/drawing/2014/main" val="2649681342"/>
                    </a:ext>
                  </a:extLst>
                </a:gridCol>
                <a:gridCol w="882650">
                  <a:extLst>
                    <a:ext uri="{9D8B030D-6E8A-4147-A177-3AD203B41FA5}">
                      <a16:colId xmlns:a16="http://schemas.microsoft.com/office/drawing/2014/main" val="3409479654"/>
                    </a:ext>
                  </a:extLst>
                </a:gridCol>
                <a:gridCol w="508000">
                  <a:extLst>
                    <a:ext uri="{9D8B030D-6E8A-4147-A177-3AD203B41FA5}">
                      <a16:colId xmlns:a16="http://schemas.microsoft.com/office/drawing/2014/main" val="337876346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 1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2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3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2138024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5a+HB1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6a +HB1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40023914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B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5a+HB2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6a+HB2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0889583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C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-v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26565785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33353348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5b+HB1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6a+HB1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0588708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 dirty="0">
                          <a:effectLst/>
                        </a:rPr>
                        <a:t>F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5b+HB2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100">
                          <a:effectLst/>
                        </a:rPr>
                        <a:t>F6a+HB2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/>
                </a:tc>
                <a:extLst>
                  <a:ext uri="{0D108BD9-81ED-4DB2-BD59-A6C34878D82A}">
                    <a16:rowId xmlns:a16="http://schemas.microsoft.com/office/drawing/2014/main" val="12842769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8539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</TotalTime>
  <Words>3733</Words>
  <Application>Microsoft Office PowerPoint</Application>
  <PresentationFormat>A4 Paper (210x297 mm)</PresentationFormat>
  <Paragraphs>1585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5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lary Rogers</dc:creator>
  <cp:lastModifiedBy>Hilary Rogers</cp:lastModifiedBy>
  <cp:revision>35</cp:revision>
  <dcterms:created xsi:type="dcterms:W3CDTF">2022-11-21T17:37:30Z</dcterms:created>
  <dcterms:modified xsi:type="dcterms:W3CDTF">2024-02-14T14:47:14Z</dcterms:modified>
</cp:coreProperties>
</file>